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6" r:id="rId2"/>
    <p:sldId id="257" r:id="rId3"/>
    <p:sldId id="262" r:id="rId4"/>
    <p:sldId id="258" r:id="rId5"/>
    <p:sldId id="259" r:id="rId6"/>
    <p:sldId id="260" r:id="rId7"/>
    <p:sldId id="263" r:id="rId8"/>
    <p:sldId id="261" r:id="rId9"/>
  </p:sldIdLst>
  <p:sldSz cx="15119350" cy="21383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1264442-212D-406E-BAB8-6052A94FD241}" v="46" dt="2024-03-15T03:02:23.92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35" d="100"/>
          <a:sy n="35" d="100"/>
        </p:scale>
        <p:origin x="238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ja Bronnert" userId="b052a95c-f3aa-4b3c-9053-3af86ea72be5" providerId="ADAL" clId="{61264442-212D-406E-BAB8-6052A94FD241}"/>
    <pc:docChg chg="undo redo custSel addSld modSld">
      <pc:chgData name="Anja Bronnert" userId="b052a95c-f3aa-4b3c-9053-3af86ea72be5" providerId="ADAL" clId="{61264442-212D-406E-BAB8-6052A94FD241}" dt="2024-03-15T03:09:36.372" v="2340" actId="1076"/>
      <pc:docMkLst>
        <pc:docMk/>
      </pc:docMkLst>
      <pc:sldChg chg="addSp delSp modSp mod">
        <pc:chgData name="Anja Bronnert" userId="b052a95c-f3aa-4b3c-9053-3af86ea72be5" providerId="ADAL" clId="{61264442-212D-406E-BAB8-6052A94FD241}" dt="2024-03-15T02:41:48.945" v="449" actId="1076"/>
        <pc:sldMkLst>
          <pc:docMk/>
          <pc:sldMk cId="2663384740" sldId="256"/>
        </pc:sldMkLst>
        <pc:spChg chg="add del mod topLvl">
          <ac:chgData name="Anja Bronnert" userId="b052a95c-f3aa-4b3c-9053-3af86ea72be5" providerId="ADAL" clId="{61264442-212D-406E-BAB8-6052A94FD241}" dt="2024-03-15T02:35:28.149" v="329" actId="21"/>
          <ac:spMkLst>
            <pc:docMk/>
            <pc:sldMk cId="2663384740" sldId="256"/>
            <ac:spMk id="2" creationId="{22FC4D48-C251-548F-54C9-7014349674AB}"/>
          </ac:spMkLst>
        </pc:spChg>
        <pc:spChg chg="add del mod topLvl">
          <ac:chgData name="Anja Bronnert" userId="b052a95c-f3aa-4b3c-9053-3af86ea72be5" providerId="ADAL" clId="{61264442-212D-406E-BAB8-6052A94FD241}" dt="2024-03-15T02:35:19.322" v="326" actId="21"/>
          <ac:spMkLst>
            <pc:docMk/>
            <pc:sldMk cId="2663384740" sldId="256"/>
            <ac:spMk id="3" creationId="{9F98C436-675B-4A0A-9F4C-7334F500814D}"/>
          </ac:spMkLst>
        </pc:spChg>
        <pc:spChg chg="mod topLvl">
          <ac:chgData name="Anja Bronnert" userId="b052a95c-f3aa-4b3c-9053-3af86ea72be5" providerId="ADAL" clId="{61264442-212D-406E-BAB8-6052A94FD241}" dt="2024-03-15T02:41:31.674" v="436" actId="1076"/>
          <ac:spMkLst>
            <pc:docMk/>
            <pc:sldMk cId="2663384740" sldId="256"/>
            <ac:spMk id="4" creationId="{7B094110-23E6-6E85-68CD-771E6130E409}"/>
          </ac:spMkLst>
        </pc:spChg>
        <pc:spChg chg="add del mod topLvl">
          <ac:chgData name="Anja Bronnert" userId="b052a95c-f3aa-4b3c-9053-3af86ea72be5" providerId="ADAL" clId="{61264442-212D-406E-BAB8-6052A94FD241}" dt="2024-03-15T02:35:19.322" v="326" actId="21"/>
          <ac:spMkLst>
            <pc:docMk/>
            <pc:sldMk cId="2663384740" sldId="256"/>
            <ac:spMk id="5" creationId="{7C9D38CF-394B-17C2-82AF-91E41E7731E1}"/>
          </ac:spMkLst>
        </pc:spChg>
        <pc:spChg chg="add mod">
          <ac:chgData name="Anja Bronnert" userId="b052a95c-f3aa-4b3c-9053-3af86ea72be5" providerId="ADAL" clId="{61264442-212D-406E-BAB8-6052A94FD241}" dt="2024-03-15T02:40:50.768" v="408" actId="120"/>
          <ac:spMkLst>
            <pc:docMk/>
            <pc:sldMk cId="2663384740" sldId="256"/>
            <ac:spMk id="6" creationId="{D84F98C6-78A2-8265-E84F-D4D9713198BD}"/>
          </ac:spMkLst>
        </pc:spChg>
        <pc:spChg chg="mod topLvl">
          <ac:chgData name="Anja Bronnert" userId="b052a95c-f3aa-4b3c-9053-3af86ea72be5" providerId="ADAL" clId="{61264442-212D-406E-BAB8-6052A94FD241}" dt="2024-03-15T02:41:24.995" v="434" actId="1076"/>
          <ac:spMkLst>
            <pc:docMk/>
            <pc:sldMk cId="2663384740" sldId="256"/>
            <ac:spMk id="8" creationId="{786C4650-84C6-A7BA-C7AF-7EDC4F606666}"/>
          </ac:spMkLst>
        </pc:spChg>
        <pc:spChg chg="add del mod">
          <ac:chgData name="Anja Bronnert" userId="b052a95c-f3aa-4b3c-9053-3af86ea72be5" providerId="ADAL" clId="{61264442-212D-406E-BAB8-6052A94FD241}" dt="2024-03-12T03:26:49.695" v="89" actId="478"/>
          <ac:spMkLst>
            <pc:docMk/>
            <pc:sldMk cId="2663384740" sldId="256"/>
            <ac:spMk id="9" creationId="{75BCAC6D-DAC6-F49D-0D26-C0DDBA603BFE}"/>
          </ac:spMkLst>
        </pc:spChg>
        <pc:spChg chg="mod topLvl">
          <ac:chgData name="Anja Bronnert" userId="b052a95c-f3aa-4b3c-9053-3af86ea72be5" providerId="ADAL" clId="{61264442-212D-406E-BAB8-6052A94FD241}" dt="2024-03-15T02:40:01.818" v="374" actId="403"/>
          <ac:spMkLst>
            <pc:docMk/>
            <pc:sldMk cId="2663384740" sldId="256"/>
            <ac:spMk id="10" creationId="{AC00B5AB-9544-204E-C7EB-B8D492765EF2}"/>
          </ac:spMkLst>
        </pc:spChg>
        <pc:spChg chg="add del mod topLvl">
          <ac:chgData name="Anja Bronnert" userId="b052a95c-f3aa-4b3c-9053-3af86ea72be5" providerId="ADAL" clId="{61264442-212D-406E-BAB8-6052A94FD241}" dt="2024-03-15T02:35:28.149" v="329" actId="21"/>
          <ac:spMkLst>
            <pc:docMk/>
            <pc:sldMk cId="2663384740" sldId="256"/>
            <ac:spMk id="11" creationId="{75BCAC6D-DAC6-F49D-0D26-C0DDBA603BFE}"/>
          </ac:spMkLst>
        </pc:spChg>
        <pc:spChg chg="mod topLvl">
          <ac:chgData name="Anja Bronnert" userId="b052a95c-f3aa-4b3c-9053-3af86ea72be5" providerId="ADAL" clId="{61264442-212D-406E-BAB8-6052A94FD241}" dt="2024-03-15T02:40:01.818" v="374" actId="403"/>
          <ac:spMkLst>
            <pc:docMk/>
            <pc:sldMk cId="2663384740" sldId="256"/>
            <ac:spMk id="12" creationId="{CDA9C8CF-C6BA-A327-5836-9293CF5543AC}"/>
          </ac:spMkLst>
        </pc:spChg>
        <pc:spChg chg="add del mod topLvl">
          <ac:chgData name="Anja Bronnert" userId="b052a95c-f3aa-4b3c-9053-3af86ea72be5" providerId="ADAL" clId="{61264442-212D-406E-BAB8-6052A94FD241}" dt="2024-03-15T02:35:28.149" v="329" actId="21"/>
          <ac:spMkLst>
            <pc:docMk/>
            <pc:sldMk cId="2663384740" sldId="256"/>
            <ac:spMk id="13" creationId="{1DE4F0DA-D9D1-C604-6A42-C8CB2AFE3196}"/>
          </ac:spMkLst>
        </pc:spChg>
        <pc:spChg chg="mod topLvl">
          <ac:chgData name="Anja Bronnert" userId="b052a95c-f3aa-4b3c-9053-3af86ea72be5" providerId="ADAL" clId="{61264442-212D-406E-BAB8-6052A94FD241}" dt="2024-03-15T02:40:01.818" v="374" actId="403"/>
          <ac:spMkLst>
            <pc:docMk/>
            <pc:sldMk cId="2663384740" sldId="256"/>
            <ac:spMk id="14" creationId="{32D046F6-CDEA-DA25-6C56-C2FAE57E00D4}"/>
          </ac:spMkLst>
        </pc:spChg>
        <pc:spChg chg="add del mod topLvl">
          <ac:chgData name="Anja Bronnert" userId="b052a95c-f3aa-4b3c-9053-3af86ea72be5" providerId="ADAL" clId="{61264442-212D-406E-BAB8-6052A94FD241}" dt="2024-03-15T02:35:28.149" v="329" actId="21"/>
          <ac:spMkLst>
            <pc:docMk/>
            <pc:sldMk cId="2663384740" sldId="256"/>
            <ac:spMk id="15" creationId="{40573375-4223-C03D-4C1F-57F5DAD3405E}"/>
          </ac:spMkLst>
        </pc:spChg>
        <pc:spChg chg="mod topLvl">
          <ac:chgData name="Anja Bronnert" userId="b052a95c-f3aa-4b3c-9053-3af86ea72be5" providerId="ADAL" clId="{61264442-212D-406E-BAB8-6052A94FD241}" dt="2024-03-15T02:40:23.604" v="380" actId="404"/>
          <ac:spMkLst>
            <pc:docMk/>
            <pc:sldMk cId="2663384740" sldId="256"/>
            <ac:spMk id="25" creationId="{7B2BB0C6-3E8B-A3E8-056A-2C8010517EDC}"/>
          </ac:spMkLst>
        </pc:spChg>
        <pc:spChg chg="del mod topLvl">
          <ac:chgData name="Anja Bronnert" userId="b052a95c-f3aa-4b3c-9053-3af86ea72be5" providerId="ADAL" clId="{61264442-212D-406E-BAB8-6052A94FD241}" dt="2024-03-15T02:35:19.322" v="326" actId="21"/>
          <ac:spMkLst>
            <pc:docMk/>
            <pc:sldMk cId="2663384740" sldId="256"/>
            <ac:spMk id="28" creationId="{8843084D-3D21-6EB9-CE1D-5797D2672AB3}"/>
          </ac:spMkLst>
        </pc:spChg>
        <pc:spChg chg="del mod topLvl">
          <ac:chgData name="Anja Bronnert" userId="b052a95c-f3aa-4b3c-9053-3af86ea72be5" providerId="ADAL" clId="{61264442-212D-406E-BAB8-6052A94FD241}" dt="2024-03-15T02:35:19.322" v="326" actId="21"/>
          <ac:spMkLst>
            <pc:docMk/>
            <pc:sldMk cId="2663384740" sldId="256"/>
            <ac:spMk id="29" creationId="{36D20541-1980-D0D3-523D-AD57414BE9EB}"/>
          </ac:spMkLst>
        </pc:spChg>
        <pc:spChg chg="del mod topLvl">
          <ac:chgData name="Anja Bronnert" userId="b052a95c-f3aa-4b3c-9053-3af86ea72be5" providerId="ADAL" clId="{61264442-212D-406E-BAB8-6052A94FD241}" dt="2024-03-15T02:35:28.149" v="329" actId="21"/>
          <ac:spMkLst>
            <pc:docMk/>
            <pc:sldMk cId="2663384740" sldId="256"/>
            <ac:spMk id="34" creationId="{75A6ABB3-69C7-5EAB-4D1C-318B9582FE6B}"/>
          </ac:spMkLst>
        </pc:spChg>
        <pc:spChg chg="del mod topLvl">
          <ac:chgData name="Anja Bronnert" userId="b052a95c-f3aa-4b3c-9053-3af86ea72be5" providerId="ADAL" clId="{61264442-212D-406E-BAB8-6052A94FD241}" dt="2024-03-15T02:35:56.773" v="332" actId="21"/>
          <ac:spMkLst>
            <pc:docMk/>
            <pc:sldMk cId="2663384740" sldId="256"/>
            <ac:spMk id="39" creationId="{FB502D71-6217-21AD-CB9A-2E79815129FB}"/>
          </ac:spMkLst>
        </pc:spChg>
        <pc:spChg chg="del mod topLvl">
          <ac:chgData name="Anja Bronnert" userId="b052a95c-f3aa-4b3c-9053-3af86ea72be5" providerId="ADAL" clId="{61264442-212D-406E-BAB8-6052A94FD241}" dt="2024-03-15T02:36:08.990" v="334" actId="21"/>
          <ac:spMkLst>
            <pc:docMk/>
            <pc:sldMk cId="2663384740" sldId="256"/>
            <ac:spMk id="40" creationId="{EC4BFA1F-3BE3-7028-CA7A-B7C553A0AFAE}"/>
          </ac:spMkLst>
        </pc:spChg>
        <pc:spChg chg="del mod topLvl">
          <ac:chgData name="Anja Bronnert" userId="b052a95c-f3aa-4b3c-9053-3af86ea72be5" providerId="ADAL" clId="{61264442-212D-406E-BAB8-6052A94FD241}" dt="2024-03-15T02:36:08.990" v="334" actId="21"/>
          <ac:spMkLst>
            <pc:docMk/>
            <pc:sldMk cId="2663384740" sldId="256"/>
            <ac:spMk id="43" creationId="{386318B0-8D50-CCE1-B2FF-00E17BEF008D}"/>
          </ac:spMkLst>
        </pc:spChg>
        <pc:spChg chg="del mod topLvl">
          <ac:chgData name="Anja Bronnert" userId="b052a95c-f3aa-4b3c-9053-3af86ea72be5" providerId="ADAL" clId="{61264442-212D-406E-BAB8-6052A94FD241}" dt="2024-03-15T02:36:08.990" v="334" actId="21"/>
          <ac:spMkLst>
            <pc:docMk/>
            <pc:sldMk cId="2663384740" sldId="256"/>
            <ac:spMk id="44" creationId="{AAA33D69-54B8-F685-4D27-77FCA1A6F304}"/>
          </ac:spMkLst>
        </pc:spChg>
        <pc:spChg chg="del mod topLvl">
          <ac:chgData name="Anja Bronnert" userId="b052a95c-f3aa-4b3c-9053-3af86ea72be5" providerId="ADAL" clId="{61264442-212D-406E-BAB8-6052A94FD241}" dt="2024-03-15T02:36:08.990" v="334" actId="21"/>
          <ac:spMkLst>
            <pc:docMk/>
            <pc:sldMk cId="2663384740" sldId="256"/>
            <ac:spMk id="45" creationId="{083E567D-35E2-861D-7188-C90EA2A4E12C}"/>
          </ac:spMkLst>
        </pc:spChg>
        <pc:spChg chg="del mod topLvl">
          <ac:chgData name="Anja Bronnert" userId="b052a95c-f3aa-4b3c-9053-3af86ea72be5" providerId="ADAL" clId="{61264442-212D-406E-BAB8-6052A94FD241}" dt="2024-03-15T02:36:08.990" v="334" actId="21"/>
          <ac:spMkLst>
            <pc:docMk/>
            <pc:sldMk cId="2663384740" sldId="256"/>
            <ac:spMk id="46" creationId="{E0E40BE0-6E54-875E-27C2-B35D363504E4}"/>
          </ac:spMkLst>
        </pc:spChg>
        <pc:spChg chg="add del mod topLvl">
          <ac:chgData name="Anja Bronnert" userId="b052a95c-f3aa-4b3c-9053-3af86ea72be5" providerId="ADAL" clId="{61264442-212D-406E-BAB8-6052A94FD241}" dt="2024-03-15T02:35:19.322" v="326" actId="21"/>
          <ac:spMkLst>
            <pc:docMk/>
            <pc:sldMk cId="2663384740" sldId="256"/>
            <ac:spMk id="55" creationId="{CA3D18A1-E631-DE50-4ADD-CB1C250291F0}"/>
          </ac:spMkLst>
        </pc:spChg>
        <pc:spChg chg="del mod topLvl">
          <ac:chgData name="Anja Bronnert" userId="b052a95c-f3aa-4b3c-9053-3af86ea72be5" providerId="ADAL" clId="{61264442-212D-406E-BAB8-6052A94FD241}" dt="2024-03-15T02:36:37.573" v="336" actId="21"/>
          <ac:spMkLst>
            <pc:docMk/>
            <pc:sldMk cId="2663384740" sldId="256"/>
            <ac:spMk id="57" creationId="{8AA60919-5649-7340-EA83-6E1DB7B0727E}"/>
          </ac:spMkLst>
        </pc:spChg>
        <pc:spChg chg="del mod topLvl">
          <ac:chgData name="Anja Bronnert" userId="b052a95c-f3aa-4b3c-9053-3af86ea72be5" providerId="ADAL" clId="{61264442-212D-406E-BAB8-6052A94FD241}" dt="2024-03-15T02:36:52.377" v="338" actId="21"/>
          <ac:spMkLst>
            <pc:docMk/>
            <pc:sldMk cId="2663384740" sldId="256"/>
            <ac:spMk id="58" creationId="{4C2B6F63-EF80-A589-5B79-DD9B52260CC4}"/>
          </ac:spMkLst>
        </pc:spChg>
        <pc:spChg chg="del mod topLvl">
          <ac:chgData name="Anja Bronnert" userId="b052a95c-f3aa-4b3c-9053-3af86ea72be5" providerId="ADAL" clId="{61264442-212D-406E-BAB8-6052A94FD241}" dt="2024-03-12T03:21:18.458" v="10" actId="21"/>
          <ac:spMkLst>
            <pc:docMk/>
            <pc:sldMk cId="2663384740" sldId="256"/>
            <ac:spMk id="59" creationId="{27A12A21-D84F-8F44-6FFB-49CA8B1468FD}"/>
          </ac:spMkLst>
        </pc:spChg>
        <pc:spChg chg="del mod topLvl">
          <ac:chgData name="Anja Bronnert" userId="b052a95c-f3aa-4b3c-9053-3af86ea72be5" providerId="ADAL" clId="{61264442-212D-406E-BAB8-6052A94FD241}" dt="2024-03-15T02:36:52.377" v="338" actId="21"/>
          <ac:spMkLst>
            <pc:docMk/>
            <pc:sldMk cId="2663384740" sldId="256"/>
            <ac:spMk id="60" creationId="{14273051-365E-5B49-B3A6-47525D0D35B9}"/>
          </ac:spMkLst>
        </pc:spChg>
        <pc:spChg chg="del mod topLvl">
          <ac:chgData name="Anja Bronnert" userId="b052a95c-f3aa-4b3c-9053-3af86ea72be5" providerId="ADAL" clId="{61264442-212D-406E-BAB8-6052A94FD241}" dt="2024-03-15T02:36:52.377" v="338" actId="21"/>
          <ac:spMkLst>
            <pc:docMk/>
            <pc:sldMk cId="2663384740" sldId="256"/>
            <ac:spMk id="61" creationId="{4C67B581-276C-13B7-78A6-526CB7E48D1D}"/>
          </ac:spMkLst>
        </pc:spChg>
        <pc:spChg chg="del mod topLvl">
          <ac:chgData name="Anja Bronnert" userId="b052a95c-f3aa-4b3c-9053-3af86ea72be5" providerId="ADAL" clId="{61264442-212D-406E-BAB8-6052A94FD241}" dt="2024-03-15T02:36:37.573" v="336" actId="21"/>
          <ac:spMkLst>
            <pc:docMk/>
            <pc:sldMk cId="2663384740" sldId="256"/>
            <ac:spMk id="62" creationId="{065852C7-CB42-4087-F0B8-3747C92CC658}"/>
          </ac:spMkLst>
        </pc:spChg>
        <pc:spChg chg="del mod topLvl">
          <ac:chgData name="Anja Bronnert" userId="b052a95c-f3aa-4b3c-9053-3af86ea72be5" providerId="ADAL" clId="{61264442-212D-406E-BAB8-6052A94FD241}" dt="2024-03-15T02:36:52.377" v="338" actId="21"/>
          <ac:spMkLst>
            <pc:docMk/>
            <pc:sldMk cId="2663384740" sldId="256"/>
            <ac:spMk id="63" creationId="{7ECA9371-ABC9-2BAF-A966-63F27A9C3D31}"/>
          </ac:spMkLst>
        </pc:spChg>
        <pc:spChg chg="del mod topLvl">
          <ac:chgData name="Anja Bronnert" userId="b052a95c-f3aa-4b3c-9053-3af86ea72be5" providerId="ADAL" clId="{61264442-212D-406E-BAB8-6052A94FD241}" dt="2024-03-15T02:36:52.377" v="338" actId="21"/>
          <ac:spMkLst>
            <pc:docMk/>
            <pc:sldMk cId="2663384740" sldId="256"/>
            <ac:spMk id="64" creationId="{01DBE269-231F-9147-9EE2-4C78EE25586C}"/>
          </ac:spMkLst>
        </pc:spChg>
        <pc:spChg chg="del mod topLvl">
          <ac:chgData name="Anja Bronnert" userId="b052a95c-f3aa-4b3c-9053-3af86ea72be5" providerId="ADAL" clId="{61264442-212D-406E-BAB8-6052A94FD241}" dt="2024-03-15T02:36:52.377" v="338" actId="21"/>
          <ac:spMkLst>
            <pc:docMk/>
            <pc:sldMk cId="2663384740" sldId="256"/>
            <ac:spMk id="65" creationId="{C030EF31-DCBE-2397-7A41-65858DD135D1}"/>
          </ac:spMkLst>
        </pc:spChg>
        <pc:spChg chg="del mod topLvl">
          <ac:chgData name="Anja Bronnert" userId="b052a95c-f3aa-4b3c-9053-3af86ea72be5" providerId="ADAL" clId="{61264442-212D-406E-BAB8-6052A94FD241}" dt="2024-03-15T02:36:52.377" v="338" actId="21"/>
          <ac:spMkLst>
            <pc:docMk/>
            <pc:sldMk cId="2663384740" sldId="256"/>
            <ac:spMk id="66" creationId="{CAE02058-29C9-63B1-B1F3-217193872B96}"/>
          </ac:spMkLst>
        </pc:spChg>
        <pc:spChg chg="del mod topLvl">
          <ac:chgData name="Anja Bronnert" userId="b052a95c-f3aa-4b3c-9053-3af86ea72be5" providerId="ADAL" clId="{61264442-212D-406E-BAB8-6052A94FD241}" dt="2024-03-15T02:36:58.949" v="340" actId="21"/>
          <ac:spMkLst>
            <pc:docMk/>
            <pc:sldMk cId="2663384740" sldId="256"/>
            <ac:spMk id="88" creationId="{556FCC52-795A-E545-637D-D3CDA92C5D76}"/>
          </ac:spMkLst>
        </pc:spChg>
        <pc:spChg chg="del mod topLvl">
          <ac:chgData name="Anja Bronnert" userId="b052a95c-f3aa-4b3c-9053-3af86ea72be5" providerId="ADAL" clId="{61264442-212D-406E-BAB8-6052A94FD241}" dt="2024-03-15T02:36:58.949" v="340" actId="21"/>
          <ac:spMkLst>
            <pc:docMk/>
            <pc:sldMk cId="2663384740" sldId="256"/>
            <ac:spMk id="89" creationId="{566B8940-AC7D-3B4E-C7E5-E8B5FBA8DAAD}"/>
          </ac:spMkLst>
        </pc:spChg>
        <pc:spChg chg="del mod topLvl">
          <ac:chgData name="Anja Bronnert" userId="b052a95c-f3aa-4b3c-9053-3af86ea72be5" providerId="ADAL" clId="{61264442-212D-406E-BAB8-6052A94FD241}" dt="2024-03-15T02:36:58.949" v="340" actId="21"/>
          <ac:spMkLst>
            <pc:docMk/>
            <pc:sldMk cId="2663384740" sldId="256"/>
            <ac:spMk id="90" creationId="{997789E9-272D-3019-568D-055FF70243DD}"/>
          </ac:spMkLst>
        </pc:spChg>
        <pc:grpChg chg="add mod">
          <ac:chgData name="Anja Bronnert" userId="b052a95c-f3aa-4b3c-9053-3af86ea72be5" providerId="ADAL" clId="{61264442-212D-406E-BAB8-6052A94FD241}" dt="2024-03-15T02:41:48.945" v="449" actId="1076"/>
          <ac:grpSpMkLst>
            <pc:docMk/>
            <pc:sldMk cId="2663384740" sldId="256"/>
            <ac:grpSpMk id="7" creationId="{C8228E25-368A-336F-080D-AF87F7FF1554}"/>
          </ac:grpSpMkLst>
        </pc:grpChg>
        <pc:grpChg chg="add del mod">
          <ac:chgData name="Anja Bronnert" userId="b052a95c-f3aa-4b3c-9053-3af86ea72be5" providerId="ADAL" clId="{61264442-212D-406E-BAB8-6052A94FD241}" dt="2024-03-12T03:31:50.041" v="135" actId="165"/>
          <ac:grpSpMkLst>
            <pc:docMk/>
            <pc:sldMk cId="2663384740" sldId="256"/>
            <ac:grpSpMk id="75" creationId="{08BA1005-EEFF-CFEA-3EE5-3B958B5B7F18}"/>
          </ac:grpSpMkLst>
        </pc:grpChg>
        <pc:grpChg chg="add del mod">
          <ac:chgData name="Anja Bronnert" userId="b052a95c-f3aa-4b3c-9053-3af86ea72be5" providerId="ADAL" clId="{61264442-212D-406E-BAB8-6052A94FD241}" dt="2024-03-15T02:35:15.209" v="325" actId="165"/>
          <ac:grpSpMkLst>
            <pc:docMk/>
            <pc:sldMk cId="2663384740" sldId="256"/>
            <ac:grpSpMk id="91" creationId="{DB2B33C9-4863-2AD7-D151-D7D1955BC641}"/>
          </ac:grpSpMkLst>
        </pc:grpChg>
        <pc:grpChg chg="del mod">
          <ac:chgData name="Anja Bronnert" userId="b052a95c-f3aa-4b3c-9053-3af86ea72be5" providerId="ADAL" clId="{61264442-212D-406E-BAB8-6052A94FD241}" dt="2024-03-12T03:19:56.685" v="3" actId="165"/>
          <ac:grpSpMkLst>
            <pc:docMk/>
            <pc:sldMk cId="2663384740" sldId="256"/>
            <ac:grpSpMk id="103" creationId="{204C0DC6-BF21-DE74-1D66-ADCCECF45B68}"/>
          </ac:grpSpMkLst>
        </pc:grpChg>
        <pc:picChg chg="add del mod">
          <ac:chgData name="Anja Bronnert" userId="b052a95c-f3aa-4b3c-9053-3af86ea72be5" providerId="ADAL" clId="{61264442-212D-406E-BAB8-6052A94FD241}" dt="2024-03-12T03:25:46.030" v="68" actId="478"/>
          <ac:picMkLst>
            <pc:docMk/>
            <pc:sldMk cId="2663384740" sldId="256"/>
            <ac:picMk id="6" creationId="{068B22E5-BC9F-9B8A-3E9E-91B1EDA6D45E}"/>
          </ac:picMkLst>
        </pc:picChg>
        <pc:picChg chg="add del mod">
          <ac:chgData name="Anja Bronnert" userId="b052a95c-f3aa-4b3c-9053-3af86ea72be5" providerId="ADAL" clId="{61264442-212D-406E-BAB8-6052A94FD241}" dt="2024-03-12T03:25:59.053" v="73" actId="478"/>
          <ac:picMkLst>
            <pc:docMk/>
            <pc:sldMk cId="2663384740" sldId="256"/>
            <ac:picMk id="7" creationId="{1230D4D4-DE6D-B8EF-B6B8-E073A2FBA6FE}"/>
          </ac:picMkLst>
        </pc:picChg>
        <pc:picChg chg="mod topLvl">
          <ac:chgData name="Anja Bronnert" userId="b052a95c-f3aa-4b3c-9053-3af86ea72be5" providerId="ADAL" clId="{61264442-212D-406E-BAB8-6052A94FD241}" dt="2024-03-15T02:41:27.802" v="435" actId="1076"/>
          <ac:picMkLst>
            <pc:docMk/>
            <pc:sldMk cId="2663384740" sldId="256"/>
            <ac:picMk id="16" creationId="{F2A3A1AC-02F8-23F0-E2EB-02E7114BF059}"/>
          </ac:picMkLst>
        </pc:picChg>
        <pc:picChg chg="add del mod">
          <ac:chgData name="Anja Bronnert" userId="b052a95c-f3aa-4b3c-9053-3af86ea72be5" providerId="ADAL" clId="{61264442-212D-406E-BAB8-6052A94FD241}" dt="2024-03-12T03:26:11.544" v="79" actId="478"/>
          <ac:picMkLst>
            <pc:docMk/>
            <pc:sldMk cId="2663384740" sldId="256"/>
            <ac:picMk id="17" creationId="{0C1461AB-4925-E0DD-5248-370E71944A0B}"/>
          </ac:picMkLst>
        </pc:picChg>
        <pc:picChg chg="mod topLvl">
          <ac:chgData name="Anja Bronnert" userId="b052a95c-f3aa-4b3c-9053-3af86ea72be5" providerId="ADAL" clId="{61264442-212D-406E-BAB8-6052A94FD241}" dt="2024-03-15T02:38:50.648" v="349" actId="164"/>
          <ac:picMkLst>
            <pc:docMk/>
            <pc:sldMk cId="2663384740" sldId="256"/>
            <ac:picMk id="18" creationId="{0CA4DE54-3F97-BF96-7CDD-113BB374A61D}"/>
          </ac:picMkLst>
        </pc:picChg>
        <pc:picChg chg="add del mod">
          <ac:chgData name="Anja Bronnert" userId="b052a95c-f3aa-4b3c-9053-3af86ea72be5" providerId="ADAL" clId="{61264442-212D-406E-BAB8-6052A94FD241}" dt="2024-03-12T03:26:41.186" v="85" actId="478"/>
          <ac:picMkLst>
            <pc:docMk/>
            <pc:sldMk cId="2663384740" sldId="256"/>
            <ac:picMk id="19" creationId="{625B0A85-EE1D-9F94-92AE-FD06A8486E8B}"/>
          </ac:picMkLst>
        </pc:picChg>
        <pc:picChg chg="mod topLvl">
          <ac:chgData name="Anja Bronnert" userId="b052a95c-f3aa-4b3c-9053-3af86ea72be5" providerId="ADAL" clId="{61264442-212D-406E-BAB8-6052A94FD241}" dt="2024-03-15T02:38:50.648" v="349" actId="164"/>
          <ac:picMkLst>
            <pc:docMk/>
            <pc:sldMk cId="2663384740" sldId="256"/>
            <ac:picMk id="20" creationId="{C1CEA4EF-56E9-C210-A6EA-A25EFD084B51}"/>
          </ac:picMkLst>
        </pc:picChg>
        <pc:picChg chg="add del mod">
          <ac:chgData name="Anja Bronnert" userId="b052a95c-f3aa-4b3c-9053-3af86ea72be5" providerId="ADAL" clId="{61264442-212D-406E-BAB8-6052A94FD241}" dt="2024-03-12T03:26:31.830" v="82" actId="478"/>
          <ac:picMkLst>
            <pc:docMk/>
            <pc:sldMk cId="2663384740" sldId="256"/>
            <ac:picMk id="21" creationId="{D0E3D9C7-0C70-BA75-6EDB-B7D934253EAA}"/>
          </ac:picMkLst>
        </pc:picChg>
        <pc:picChg chg="mod topLvl">
          <ac:chgData name="Anja Bronnert" userId="b052a95c-f3aa-4b3c-9053-3af86ea72be5" providerId="ADAL" clId="{61264442-212D-406E-BAB8-6052A94FD241}" dt="2024-03-15T02:38:50.648" v="349" actId="164"/>
          <ac:picMkLst>
            <pc:docMk/>
            <pc:sldMk cId="2663384740" sldId="256"/>
            <ac:picMk id="22" creationId="{5A400EDE-7667-E2AD-6953-95D75E4D2E57}"/>
          </ac:picMkLst>
        </pc:picChg>
        <pc:picChg chg="mod topLvl">
          <ac:chgData name="Anja Bronnert" userId="b052a95c-f3aa-4b3c-9053-3af86ea72be5" providerId="ADAL" clId="{61264442-212D-406E-BAB8-6052A94FD241}" dt="2024-03-15T02:38:50.648" v="349" actId="164"/>
          <ac:picMkLst>
            <pc:docMk/>
            <pc:sldMk cId="2663384740" sldId="256"/>
            <ac:picMk id="24" creationId="{118B5BCE-D2C4-A422-00D6-14B3A8524047}"/>
          </ac:picMkLst>
        </pc:picChg>
        <pc:picChg chg="add del mod">
          <ac:chgData name="Anja Bronnert" userId="b052a95c-f3aa-4b3c-9053-3af86ea72be5" providerId="ADAL" clId="{61264442-212D-406E-BAB8-6052A94FD241}" dt="2024-03-12T03:25:54.238" v="70" actId="478"/>
          <ac:picMkLst>
            <pc:docMk/>
            <pc:sldMk cId="2663384740" sldId="256"/>
            <ac:picMk id="26" creationId="{0AF54EE2-DFF5-4F1D-DE5C-7A2E9696B59F}"/>
          </ac:picMkLst>
        </pc:picChg>
        <pc:picChg chg="mod topLvl">
          <ac:chgData name="Anja Bronnert" userId="b052a95c-f3aa-4b3c-9053-3af86ea72be5" providerId="ADAL" clId="{61264442-212D-406E-BAB8-6052A94FD241}" dt="2024-03-15T02:38:50.648" v="349" actId="164"/>
          <ac:picMkLst>
            <pc:docMk/>
            <pc:sldMk cId="2663384740" sldId="256"/>
            <ac:picMk id="27" creationId="{6C6A8E86-21E6-9126-AA96-6141B5A94A19}"/>
          </ac:picMkLst>
        </pc:picChg>
        <pc:picChg chg="add del mod">
          <ac:chgData name="Anja Bronnert" userId="b052a95c-f3aa-4b3c-9053-3af86ea72be5" providerId="ADAL" clId="{61264442-212D-406E-BAB8-6052A94FD241}" dt="2024-03-12T03:26:05.747" v="76" actId="478"/>
          <ac:picMkLst>
            <pc:docMk/>
            <pc:sldMk cId="2663384740" sldId="256"/>
            <ac:picMk id="30" creationId="{4097E81C-E015-510C-EB61-9DAA3560716D}"/>
          </ac:picMkLst>
        </pc:picChg>
        <pc:picChg chg="del mod topLvl">
          <ac:chgData name="Anja Bronnert" userId="b052a95c-f3aa-4b3c-9053-3af86ea72be5" providerId="ADAL" clId="{61264442-212D-406E-BAB8-6052A94FD241}" dt="2024-03-12T03:34:08.453" v="149" actId="478"/>
          <ac:picMkLst>
            <pc:docMk/>
            <pc:sldMk cId="2663384740" sldId="256"/>
            <ac:picMk id="31" creationId="{90DB88C4-770E-5DEB-515C-0F37B7404D3F}"/>
          </ac:picMkLst>
        </pc:picChg>
        <pc:picChg chg="add del mod topLvl">
          <ac:chgData name="Anja Bronnert" userId="b052a95c-f3aa-4b3c-9053-3af86ea72be5" providerId="ADAL" clId="{61264442-212D-406E-BAB8-6052A94FD241}" dt="2024-03-15T02:35:19.322" v="326" actId="21"/>
          <ac:picMkLst>
            <pc:docMk/>
            <pc:sldMk cId="2663384740" sldId="256"/>
            <ac:picMk id="32" creationId="{5727D6BD-9D34-9B03-F3FF-8AAC121B23F1}"/>
          </ac:picMkLst>
        </pc:picChg>
        <pc:picChg chg="del mod topLvl">
          <ac:chgData name="Anja Bronnert" userId="b052a95c-f3aa-4b3c-9053-3af86ea72be5" providerId="ADAL" clId="{61264442-212D-406E-BAB8-6052A94FD241}" dt="2024-03-12T03:34:38.117" v="153" actId="478"/>
          <ac:picMkLst>
            <pc:docMk/>
            <pc:sldMk cId="2663384740" sldId="256"/>
            <ac:picMk id="33" creationId="{9CA5FB37-1B9F-DD34-B7F5-F3EF3176B452}"/>
          </ac:picMkLst>
        </pc:picChg>
        <pc:picChg chg="del mod topLvl">
          <ac:chgData name="Anja Bronnert" userId="b052a95c-f3aa-4b3c-9053-3af86ea72be5" providerId="ADAL" clId="{61264442-212D-406E-BAB8-6052A94FD241}" dt="2024-03-15T02:35:28.149" v="329" actId="21"/>
          <ac:picMkLst>
            <pc:docMk/>
            <pc:sldMk cId="2663384740" sldId="256"/>
            <ac:picMk id="36" creationId="{998A302D-417B-A7F2-F5DF-DD1F2ADD6234}"/>
          </ac:picMkLst>
        </pc:picChg>
        <pc:picChg chg="add del mod topLvl">
          <ac:chgData name="Anja Bronnert" userId="b052a95c-f3aa-4b3c-9053-3af86ea72be5" providerId="ADAL" clId="{61264442-212D-406E-BAB8-6052A94FD241}" dt="2024-03-15T02:35:19.322" v="326" actId="21"/>
          <ac:picMkLst>
            <pc:docMk/>
            <pc:sldMk cId="2663384740" sldId="256"/>
            <ac:picMk id="37" creationId="{73998BD4-D727-CF60-3DDE-E82B0B19D4A6}"/>
          </ac:picMkLst>
        </pc:picChg>
        <pc:picChg chg="del mod topLvl">
          <ac:chgData name="Anja Bronnert" userId="b052a95c-f3aa-4b3c-9053-3af86ea72be5" providerId="ADAL" clId="{61264442-212D-406E-BAB8-6052A94FD241}" dt="2024-03-15T02:35:56.773" v="332" actId="21"/>
          <ac:picMkLst>
            <pc:docMk/>
            <pc:sldMk cId="2663384740" sldId="256"/>
            <ac:picMk id="38" creationId="{37C77D4F-7150-E87B-8C21-E3F1BF670A65}"/>
          </ac:picMkLst>
        </pc:picChg>
        <pc:picChg chg="del mod topLvl">
          <ac:chgData name="Anja Bronnert" userId="b052a95c-f3aa-4b3c-9053-3af86ea72be5" providerId="ADAL" clId="{61264442-212D-406E-BAB8-6052A94FD241}" dt="2024-03-15T02:36:08.990" v="334" actId="21"/>
          <ac:picMkLst>
            <pc:docMk/>
            <pc:sldMk cId="2663384740" sldId="256"/>
            <ac:picMk id="42" creationId="{6D464268-406E-979B-817D-789A3CAB96FE}"/>
          </ac:picMkLst>
        </pc:picChg>
        <pc:picChg chg="add del mod topLvl">
          <ac:chgData name="Anja Bronnert" userId="b052a95c-f3aa-4b3c-9053-3af86ea72be5" providerId="ADAL" clId="{61264442-212D-406E-BAB8-6052A94FD241}" dt="2024-03-15T02:35:19.322" v="326" actId="21"/>
          <ac:picMkLst>
            <pc:docMk/>
            <pc:sldMk cId="2663384740" sldId="256"/>
            <ac:picMk id="47" creationId="{7D85B45E-39A6-28BE-9C57-9778F82A6F56}"/>
          </ac:picMkLst>
        </pc:picChg>
        <pc:picChg chg="del mod topLvl">
          <ac:chgData name="Anja Bronnert" userId="b052a95c-f3aa-4b3c-9053-3af86ea72be5" providerId="ADAL" clId="{61264442-212D-406E-BAB8-6052A94FD241}" dt="2024-03-15T02:36:08.990" v="334" actId="21"/>
          <ac:picMkLst>
            <pc:docMk/>
            <pc:sldMk cId="2663384740" sldId="256"/>
            <ac:picMk id="48" creationId="{52161B3E-7EE0-DEE2-89F2-E2250E7E95B0}"/>
          </ac:picMkLst>
        </pc:picChg>
        <pc:picChg chg="del mod topLvl">
          <ac:chgData name="Anja Bronnert" userId="b052a95c-f3aa-4b3c-9053-3af86ea72be5" providerId="ADAL" clId="{61264442-212D-406E-BAB8-6052A94FD241}" dt="2024-03-15T02:36:08.990" v="334" actId="21"/>
          <ac:picMkLst>
            <pc:docMk/>
            <pc:sldMk cId="2663384740" sldId="256"/>
            <ac:picMk id="50" creationId="{17C6BEE7-8D7F-DB5F-2B24-BC0361AAC7B1}"/>
          </ac:picMkLst>
        </pc:picChg>
        <pc:picChg chg="add del mod topLvl">
          <ac:chgData name="Anja Bronnert" userId="b052a95c-f3aa-4b3c-9053-3af86ea72be5" providerId="ADAL" clId="{61264442-212D-406E-BAB8-6052A94FD241}" dt="2024-03-15T02:35:28.149" v="329" actId="21"/>
          <ac:picMkLst>
            <pc:docMk/>
            <pc:sldMk cId="2663384740" sldId="256"/>
            <ac:picMk id="51" creationId="{27F857D9-6288-1DDC-0925-02136FD6A7BF}"/>
          </ac:picMkLst>
        </pc:picChg>
        <pc:picChg chg="add del mod topLvl">
          <ac:chgData name="Anja Bronnert" userId="b052a95c-f3aa-4b3c-9053-3af86ea72be5" providerId="ADAL" clId="{61264442-212D-406E-BAB8-6052A94FD241}" dt="2024-03-15T02:35:28.149" v="329" actId="21"/>
          <ac:picMkLst>
            <pc:docMk/>
            <pc:sldMk cId="2663384740" sldId="256"/>
            <ac:picMk id="53" creationId="{FCBEE3D7-D84F-9206-3F64-FB4F03ED6D17}"/>
          </ac:picMkLst>
        </pc:picChg>
        <pc:picChg chg="del mod topLvl">
          <ac:chgData name="Anja Bronnert" userId="b052a95c-f3aa-4b3c-9053-3af86ea72be5" providerId="ADAL" clId="{61264442-212D-406E-BAB8-6052A94FD241}" dt="2024-03-15T02:36:08.990" v="334" actId="21"/>
          <ac:picMkLst>
            <pc:docMk/>
            <pc:sldMk cId="2663384740" sldId="256"/>
            <ac:picMk id="54" creationId="{A5E53B9A-AADB-9DA4-0903-09E6CF60E344}"/>
          </ac:picMkLst>
        </pc:picChg>
        <pc:picChg chg="del mod topLvl">
          <ac:chgData name="Anja Bronnert" userId="b052a95c-f3aa-4b3c-9053-3af86ea72be5" providerId="ADAL" clId="{61264442-212D-406E-BAB8-6052A94FD241}" dt="2024-03-15T02:36:08.990" v="334" actId="21"/>
          <ac:picMkLst>
            <pc:docMk/>
            <pc:sldMk cId="2663384740" sldId="256"/>
            <ac:picMk id="56" creationId="{7F581DE2-CB37-F01F-E9B1-E69D5D2AED66}"/>
          </ac:picMkLst>
        </pc:picChg>
        <pc:picChg chg="del mod topLvl">
          <ac:chgData name="Anja Bronnert" userId="b052a95c-f3aa-4b3c-9053-3af86ea72be5" providerId="ADAL" clId="{61264442-212D-406E-BAB8-6052A94FD241}" dt="2024-03-15T02:36:37.573" v="336" actId="21"/>
          <ac:picMkLst>
            <pc:docMk/>
            <pc:sldMk cId="2663384740" sldId="256"/>
            <ac:picMk id="68" creationId="{B8841804-BA18-CBC0-D5C9-784247480AC9}"/>
          </ac:picMkLst>
        </pc:picChg>
        <pc:picChg chg="add del mod topLvl">
          <ac:chgData name="Anja Bronnert" userId="b052a95c-f3aa-4b3c-9053-3af86ea72be5" providerId="ADAL" clId="{61264442-212D-406E-BAB8-6052A94FD241}" dt="2024-03-15T02:35:28.149" v="329" actId="21"/>
          <ac:picMkLst>
            <pc:docMk/>
            <pc:sldMk cId="2663384740" sldId="256"/>
            <ac:picMk id="69" creationId="{5DF73FB9-275D-9314-5210-2FC7105BFD3E}"/>
          </ac:picMkLst>
        </pc:picChg>
        <pc:picChg chg="del mod topLvl">
          <ac:chgData name="Anja Bronnert" userId="b052a95c-f3aa-4b3c-9053-3af86ea72be5" providerId="ADAL" clId="{61264442-212D-406E-BAB8-6052A94FD241}" dt="2024-03-15T02:36:37.573" v="336" actId="21"/>
          <ac:picMkLst>
            <pc:docMk/>
            <pc:sldMk cId="2663384740" sldId="256"/>
            <ac:picMk id="70" creationId="{F70B24B4-B68F-C718-24F0-6C0A40019F95}"/>
          </ac:picMkLst>
        </pc:picChg>
        <pc:picChg chg="del mod topLvl">
          <ac:chgData name="Anja Bronnert" userId="b052a95c-f3aa-4b3c-9053-3af86ea72be5" providerId="ADAL" clId="{61264442-212D-406E-BAB8-6052A94FD241}" dt="2024-03-15T02:36:52.377" v="338" actId="21"/>
          <ac:picMkLst>
            <pc:docMk/>
            <pc:sldMk cId="2663384740" sldId="256"/>
            <ac:picMk id="72" creationId="{DACDE3D8-D1C3-2E96-BE51-48CC56F42698}"/>
          </ac:picMkLst>
        </pc:picChg>
        <pc:picChg chg="add del mod topLvl">
          <ac:chgData name="Anja Bronnert" userId="b052a95c-f3aa-4b3c-9053-3af86ea72be5" providerId="ADAL" clId="{61264442-212D-406E-BAB8-6052A94FD241}" dt="2024-03-15T02:35:28.149" v="329" actId="21"/>
          <ac:picMkLst>
            <pc:docMk/>
            <pc:sldMk cId="2663384740" sldId="256"/>
            <ac:picMk id="73" creationId="{CA7E505A-75B6-BA94-7909-5B009628D15E}"/>
          </ac:picMkLst>
        </pc:picChg>
        <pc:picChg chg="del mod topLvl">
          <ac:chgData name="Anja Bronnert" userId="b052a95c-f3aa-4b3c-9053-3af86ea72be5" providerId="ADAL" clId="{61264442-212D-406E-BAB8-6052A94FD241}" dt="2024-03-12T03:21:18.458" v="10" actId="21"/>
          <ac:picMkLst>
            <pc:docMk/>
            <pc:sldMk cId="2663384740" sldId="256"/>
            <ac:picMk id="74" creationId="{54086C28-3483-D72E-B294-881888B44250}"/>
          </ac:picMkLst>
        </pc:picChg>
        <pc:picChg chg="del mod topLvl">
          <ac:chgData name="Anja Bronnert" userId="b052a95c-f3aa-4b3c-9053-3af86ea72be5" providerId="ADAL" clId="{61264442-212D-406E-BAB8-6052A94FD241}" dt="2024-03-15T02:36:52.377" v="338" actId="21"/>
          <ac:picMkLst>
            <pc:docMk/>
            <pc:sldMk cId="2663384740" sldId="256"/>
            <ac:picMk id="76" creationId="{143201C0-B2DD-FEF8-6A7A-032BB9D779DB}"/>
          </ac:picMkLst>
        </pc:picChg>
        <pc:picChg chg="del mod topLvl">
          <ac:chgData name="Anja Bronnert" userId="b052a95c-f3aa-4b3c-9053-3af86ea72be5" providerId="ADAL" clId="{61264442-212D-406E-BAB8-6052A94FD241}" dt="2024-03-15T02:36:52.377" v="338" actId="21"/>
          <ac:picMkLst>
            <pc:docMk/>
            <pc:sldMk cId="2663384740" sldId="256"/>
            <ac:picMk id="78" creationId="{F8EEA25C-3C2A-9013-10AF-2321748CAA99}"/>
          </ac:picMkLst>
        </pc:picChg>
        <pc:picChg chg="add del mod topLvl">
          <ac:chgData name="Anja Bronnert" userId="b052a95c-f3aa-4b3c-9053-3af86ea72be5" providerId="ADAL" clId="{61264442-212D-406E-BAB8-6052A94FD241}" dt="2024-03-15T02:35:19.322" v="326" actId="21"/>
          <ac:picMkLst>
            <pc:docMk/>
            <pc:sldMk cId="2663384740" sldId="256"/>
            <ac:picMk id="79" creationId="{5EF6F285-7103-541B-858C-703798AAF65A}"/>
          </ac:picMkLst>
        </pc:picChg>
        <pc:picChg chg="del mod topLvl">
          <ac:chgData name="Anja Bronnert" userId="b052a95c-f3aa-4b3c-9053-3af86ea72be5" providerId="ADAL" clId="{61264442-212D-406E-BAB8-6052A94FD241}" dt="2024-03-15T02:36:52.377" v="338" actId="21"/>
          <ac:picMkLst>
            <pc:docMk/>
            <pc:sldMk cId="2663384740" sldId="256"/>
            <ac:picMk id="81" creationId="{808B1C66-38FC-1454-89AE-632C82A0CD66}"/>
          </ac:picMkLst>
        </pc:picChg>
        <pc:picChg chg="add del mod">
          <ac:chgData name="Anja Bronnert" userId="b052a95c-f3aa-4b3c-9053-3af86ea72be5" providerId="ADAL" clId="{61264442-212D-406E-BAB8-6052A94FD241}" dt="2024-03-12T03:35:27.849" v="159" actId="478"/>
          <ac:picMkLst>
            <pc:docMk/>
            <pc:sldMk cId="2663384740" sldId="256"/>
            <ac:picMk id="82" creationId="{3C925715-B0B3-B139-F3C2-80C6F77E61CB}"/>
          </ac:picMkLst>
        </pc:picChg>
        <pc:picChg chg="del mod topLvl">
          <ac:chgData name="Anja Bronnert" userId="b052a95c-f3aa-4b3c-9053-3af86ea72be5" providerId="ADAL" clId="{61264442-212D-406E-BAB8-6052A94FD241}" dt="2024-03-15T02:36:52.377" v="338" actId="21"/>
          <ac:picMkLst>
            <pc:docMk/>
            <pc:sldMk cId="2663384740" sldId="256"/>
            <ac:picMk id="83" creationId="{34C723CF-E0A0-A061-A0D3-FA85328EC9FB}"/>
          </ac:picMkLst>
        </pc:picChg>
        <pc:picChg chg="del mod topLvl">
          <ac:chgData name="Anja Bronnert" userId="b052a95c-f3aa-4b3c-9053-3af86ea72be5" providerId="ADAL" clId="{61264442-212D-406E-BAB8-6052A94FD241}" dt="2024-03-15T02:36:52.377" v="338" actId="21"/>
          <ac:picMkLst>
            <pc:docMk/>
            <pc:sldMk cId="2663384740" sldId="256"/>
            <ac:picMk id="85" creationId="{1FBFA2CA-0E3A-FCA4-2F99-7D2FB28C5285}"/>
          </ac:picMkLst>
        </pc:picChg>
        <pc:picChg chg="add del mod topLvl">
          <ac:chgData name="Anja Bronnert" userId="b052a95c-f3aa-4b3c-9053-3af86ea72be5" providerId="ADAL" clId="{61264442-212D-406E-BAB8-6052A94FD241}" dt="2024-03-15T02:35:19.322" v="326" actId="21"/>
          <ac:picMkLst>
            <pc:docMk/>
            <pc:sldMk cId="2663384740" sldId="256"/>
            <ac:picMk id="86" creationId="{23D9D9EE-98D2-DE07-9024-29C51927CCEF}"/>
          </ac:picMkLst>
        </pc:picChg>
        <pc:picChg chg="del mod topLvl">
          <ac:chgData name="Anja Bronnert" userId="b052a95c-f3aa-4b3c-9053-3af86ea72be5" providerId="ADAL" clId="{61264442-212D-406E-BAB8-6052A94FD241}" dt="2024-03-15T02:36:52.377" v="338" actId="21"/>
          <ac:picMkLst>
            <pc:docMk/>
            <pc:sldMk cId="2663384740" sldId="256"/>
            <ac:picMk id="87" creationId="{2907FB7A-5ADF-0282-9086-414B08C0744F}"/>
          </ac:picMkLst>
        </pc:picChg>
        <pc:picChg chg="del">
          <ac:chgData name="Anja Bronnert" userId="b052a95c-f3aa-4b3c-9053-3af86ea72be5" providerId="ADAL" clId="{61264442-212D-406E-BAB8-6052A94FD241}" dt="2024-03-11T22:58:28.308" v="0" actId="478"/>
          <ac:picMkLst>
            <pc:docMk/>
            <pc:sldMk cId="2663384740" sldId="256"/>
            <ac:picMk id="92" creationId="{63BACE55-F1E0-9576-B626-3CAF47480E73}"/>
          </ac:picMkLst>
        </pc:picChg>
        <pc:picChg chg="del mod topLvl">
          <ac:chgData name="Anja Bronnert" userId="b052a95c-f3aa-4b3c-9053-3af86ea72be5" providerId="ADAL" clId="{61264442-212D-406E-BAB8-6052A94FD241}" dt="2024-03-15T02:36:58.949" v="340" actId="21"/>
          <ac:picMkLst>
            <pc:docMk/>
            <pc:sldMk cId="2663384740" sldId="256"/>
            <ac:picMk id="98" creationId="{28DA7894-9FEF-C4AB-6D35-2219BD0BD432}"/>
          </ac:picMkLst>
        </pc:picChg>
        <pc:picChg chg="del mod topLvl">
          <ac:chgData name="Anja Bronnert" userId="b052a95c-f3aa-4b3c-9053-3af86ea72be5" providerId="ADAL" clId="{61264442-212D-406E-BAB8-6052A94FD241}" dt="2024-03-15T02:36:58.949" v="340" actId="21"/>
          <ac:picMkLst>
            <pc:docMk/>
            <pc:sldMk cId="2663384740" sldId="256"/>
            <ac:picMk id="100" creationId="{121150F1-539E-A7D5-652E-E783BC54244F}"/>
          </ac:picMkLst>
        </pc:picChg>
        <pc:picChg chg="del mod topLvl">
          <ac:chgData name="Anja Bronnert" userId="b052a95c-f3aa-4b3c-9053-3af86ea72be5" providerId="ADAL" clId="{61264442-212D-406E-BAB8-6052A94FD241}" dt="2024-03-15T02:36:58.949" v="340" actId="21"/>
          <ac:picMkLst>
            <pc:docMk/>
            <pc:sldMk cId="2663384740" sldId="256"/>
            <ac:picMk id="102" creationId="{5B280C59-606F-45AA-FF9B-7F99051EDE58}"/>
          </ac:picMkLst>
        </pc:picChg>
      </pc:sldChg>
      <pc:sldChg chg="addSp delSp modSp new mod">
        <pc:chgData name="Anja Bronnert" userId="b052a95c-f3aa-4b3c-9053-3af86ea72be5" providerId="ADAL" clId="{61264442-212D-406E-BAB8-6052A94FD241}" dt="2024-03-15T02:54:04.846" v="1352" actId="1076"/>
        <pc:sldMkLst>
          <pc:docMk/>
          <pc:sldMk cId="3857424100" sldId="257"/>
        </pc:sldMkLst>
        <pc:spChg chg="del">
          <ac:chgData name="Anja Bronnert" userId="b052a95c-f3aa-4b3c-9053-3af86ea72be5" providerId="ADAL" clId="{61264442-212D-406E-BAB8-6052A94FD241}" dt="2024-03-15T02:34:57.254" v="319" actId="478"/>
          <ac:spMkLst>
            <pc:docMk/>
            <pc:sldMk cId="3857424100" sldId="257"/>
            <ac:spMk id="2" creationId="{651F4653-85B9-8F02-53AC-56ED453EC263}"/>
          </ac:spMkLst>
        </pc:spChg>
        <pc:spChg chg="del">
          <ac:chgData name="Anja Bronnert" userId="b052a95c-f3aa-4b3c-9053-3af86ea72be5" providerId="ADAL" clId="{61264442-212D-406E-BAB8-6052A94FD241}" dt="2024-03-15T02:34:58.709" v="320" actId="478"/>
          <ac:spMkLst>
            <pc:docMk/>
            <pc:sldMk cId="3857424100" sldId="257"/>
            <ac:spMk id="3" creationId="{FEC0C9E7-A10C-9C5F-E7E5-2CD08E30A92D}"/>
          </ac:spMkLst>
        </pc:spChg>
        <pc:spChg chg="add mod topLvl">
          <ac:chgData name="Anja Bronnert" userId="b052a95c-f3aa-4b3c-9053-3af86ea72be5" providerId="ADAL" clId="{61264442-212D-406E-BAB8-6052A94FD241}" dt="2024-03-15T02:52:53.778" v="1311" actId="14100"/>
          <ac:spMkLst>
            <pc:docMk/>
            <pc:sldMk cId="3857424100" sldId="257"/>
            <ac:spMk id="4" creationId="{9F98C436-675B-4A0A-9F4C-7334F500814D}"/>
          </ac:spMkLst>
        </pc:spChg>
        <pc:spChg chg="add mod topLvl">
          <ac:chgData name="Anja Bronnert" userId="b052a95c-f3aa-4b3c-9053-3af86ea72be5" providerId="ADAL" clId="{61264442-212D-406E-BAB8-6052A94FD241}" dt="2024-03-15T02:51:51.656" v="1306" actId="1076"/>
          <ac:spMkLst>
            <pc:docMk/>
            <pc:sldMk cId="3857424100" sldId="257"/>
            <ac:spMk id="5" creationId="{7C9D38CF-394B-17C2-82AF-91E41E7731E1}"/>
          </ac:spMkLst>
        </pc:spChg>
        <pc:spChg chg="add del mod topLvl">
          <ac:chgData name="Anja Bronnert" userId="b052a95c-f3aa-4b3c-9053-3af86ea72be5" providerId="ADAL" clId="{61264442-212D-406E-BAB8-6052A94FD241}" dt="2024-03-15T02:49:37.347" v="568" actId="21"/>
          <ac:spMkLst>
            <pc:docMk/>
            <pc:sldMk cId="3857424100" sldId="257"/>
            <ac:spMk id="6" creationId="{22FC4D48-C251-548F-54C9-7014349674AB}"/>
          </ac:spMkLst>
        </pc:spChg>
        <pc:spChg chg="add mod">
          <ac:chgData name="Anja Bronnert" userId="b052a95c-f3aa-4b3c-9053-3af86ea72be5" providerId="ADAL" clId="{61264442-212D-406E-BAB8-6052A94FD241}" dt="2024-03-15T02:53:57.260" v="1351" actId="1076"/>
          <ac:spMkLst>
            <pc:docMk/>
            <pc:sldMk cId="3857424100" sldId="257"/>
            <ac:spMk id="8" creationId="{22FC4D48-C251-548F-54C9-7014349674AB}"/>
          </ac:spMkLst>
        </pc:spChg>
        <pc:spChg chg="add del mod topLvl">
          <ac:chgData name="Anja Bronnert" userId="b052a95c-f3aa-4b3c-9053-3af86ea72be5" providerId="ADAL" clId="{61264442-212D-406E-BAB8-6052A94FD241}" dt="2024-03-15T02:49:37.347" v="568" actId="21"/>
          <ac:spMkLst>
            <pc:docMk/>
            <pc:sldMk cId="3857424100" sldId="257"/>
            <ac:spMk id="11" creationId="{75BCAC6D-DAC6-F49D-0D26-C0DDBA603BFE}"/>
          </ac:spMkLst>
        </pc:spChg>
        <pc:spChg chg="add del mod topLvl">
          <ac:chgData name="Anja Bronnert" userId="b052a95c-f3aa-4b3c-9053-3af86ea72be5" providerId="ADAL" clId="{61264442-212D-406E-BAB8-6052A94FD241}" dt="2024-03-15T02:49:37.347" v="568" actId="21"/>
          <ac:spMkLst>
            <pc:docMk/>
            <pc:sldMk cId="3857424100" sldId="257"/>
            <ac:spMk id="13" creationId="{1DE4F0DA-D9D1-C604-6A42-C8CB2AFE3196}"/>
          </ac:spMkLst>
        </pc:spChg>
        <pc:spChg chg="add del mod topLvl">
          <ac:chgData name="Anja Bronnert" userId="b052a95c-f3aa-4b3c-9053-3af86ea72be5" providerId="ADAL" clId="{61264442-212D-406E-BAB8-6052A94FD241}" dt="2024-03-15T02:49:37.347" v="568" actId="21"/>
          <ac:spMkLst>
            <pc:docMk/>
            <pc:sldMk cId="3857424100" sldId="257"/>
            <ac:spMk id="15" creationId="{40573375-4223-C03D-4C1F-57F5DAD3405E}"/>
          </ac:spMkLst>
        </pc:spChg>
        <pc:spChg chg="add mod topLvl">
          <ac:chgData name="Anja Bronnert" userId="b052a95c-f3aa-4b3c-9053-3af86ea72be5" providerId="ADAL" clId="{61264442-212D-406E-BAB8-6052A94FD241}" dt="2024-03-15T02:49:31.814" v="567" actId="165"/>
          <ac:spMkLst>
            <pc:docMk/>
            <pc:sldMk cId="3857424100" sldId="257"/>
            <ac:spMk id="28" creationId="{8843084D-3D21-6EB9-CE1D-5797D2672AB3}"/>
          </ac:spMkLst>
        </pc:spChg>
        <pc:spChg chg="add mod topLvl">
          <ac:chgData name="Anja Bronnert" userId="b052a95c-f3aa-4b3c-9053-3af86ea72be5" providerId="ADAL" clId="{61264442-212D-406E-BAB8-6052A94FD241}" dt="2024-03-15T02:51:25.016" v="1303" actId="14100"/>
          <ac:spMkLst>
            <pc:docMk/>
            <pc:sldMk cId="3857424100" sldId="257"/>
            <ac:spMk id="29" creationId="{36D20541-1980-D0D3-523D-AD57414BE9EB}"/>
          </ac:spMkLst>
        </pc:spChg>
        <pc:spChg chg="add del mod topLvl">
          <ac:chgData name="Anja Bronnert" userId="b052a95c-f3aa-4b3c-9053-3af86ea72be5" providerId="ADAL" clId="{61264442-212D-406E-BAB8-6052A94FD241}" dt="2024-03-15T02:49:37.347" v="568" actId="21"/>
          <ac:spMkLst>
            <pc:docMk/>
            <pc:sldMk cId="3857424100" sldId="257"/>
            <ac:spMk id="34" creationId="{75A6ABB3-69C7-5EAB-4D1C-318B9582FE6B}"/>
          </ac:spMkLst>
        </pc:spChg>
        <pc:spChg chg="add mod topLvl">
          <ac:chgData name="Anja Bronnert" userId="b052a95c-f3aa-4b3c-9053-3af86ea72be5" providerId="ADAL" clId="{61264442-212D-406E-BAB8-6052A94FD241}" dt="2024-03-15T02:53:03.303" v="1313" actId="1076"/>
          <ac:spMkLst>
            <pc:docMk/>
            <pc:sldMk cId="3857424100" sldId="257"/>
            <ac:spMk id="55" creationId="{CA3D18A1-E631-DE50-4ADD-CB1C250291F0}"/>
          </ac:spMkLst>
        </pc:spChg>
        <pc:grpChg chg="add del mod">
          <ac:chgData name="Anja Bronnert" userId="b052a95c-f3aa-4b3c-9053-3af86ea72be5" providerId="ADAL" clId="{61264442-212D-406E-BAB8-6052A94FD241}" dt="2024-03-15T02:49:31.814" v="567" actId="165"/>
          <ac:grpSpMkLst>
            <pc:docMk/>
            <pc:sldMk cId="3857424100" sldId="257"/>
            <ac:grpSpMk id="7" creationId="{189C22F9-A284-D4D6-8822-2D8C9E325BE1}"/>
          </ac:grpSpMkLst>
        </pc:grpChg>
        <pc:picChg chg="add mod">
          <ac:chgData name="Anja Bronnert" userId="b052a95c-f3aa-4b3c-9053-3af86ea72be5" providerId="ADAL" clId="{61264442-212D-406E-BAB8-6052A94FD241}" dt="2024-03-15T02:54:04.846" v="1352" actId="1076"/>
          <ac:picMkLst>
            <pc:docMk/>
            <pc:sldMk cId="3857424100" sldId="257"/>
            <ac:picMk id="9" creationId="{27F857D9-6288-1DDC-0925-02136FD6A7BF}"/>
          </ac:picMkLst>
        </pc:picChg>
        <pc:picChg chg="add mod topLvl">
          <ac:chgData name="Anja Bronnert" userId="b052a95c-f3aa-4b3c-9053-3af86ea72be5" providerId="ADAL" clId="{61264442-212D-406E-BAB8-6052A94FD241}" dt="2024-03-15T02:52:19.348" v="1307" actId="1076"/>
          <ac:picMkLst>
            <pc:docMk/>
            <pc:sldMk cId="3857424100" sldId="257"/>
            <ac:picMk id="32" creationId="{5727D6BD-9D34-9B03-F3FF-8AAC121B23F1}"/>
          </ac:picMkLst>
        </pc:picChg>
        <pc:picChg chg="add del mod topLvl">
          <ac:chgData name="Anja Bronnert" userId="b052a95c-f3aa-4b3c-9053-3af86ea72be5" providerId="ADAL" clId="{61264442-212D-406E-BAB8-6052A94FD241}" dt="2024-03-15T02:49:37.347" v="568" actId="21"/>
          <ac:picMkLst>
            <pc:docMk/>
            <pc:sldMk cId="3857424100" sldId="257"/>
            <ac:picMk id="36" creationId="{998A302D-417B-A7F2-F5DF-DD1F2ADD6234}"/>
          </ac:picMkLst>
        </pc:picChg>
        <pc:picChg chg="add mod topLvl">
          <ac:chgData name="Anja Bronnert" userId="b052a95c-f3aa-4b3c-9053-3af86ea72be5" providerId="ADAL" clId="{61264442-212D-406E-BAB8-6052A94FD241}" dt="2024-03-15T02:52:59.134" v="1312" actId="1076"/>
          <ac:picMkLst>
            <pc:docMk/>
            <pc:sldMk cId="3857424100" sldId="257"/>
            <ac:picMk id="37" creationId="{73998BD4-D727-CF60-3DDE-E82B0B19D4A6}"/>
          </ac:picMkLst>
        </pc:picChg>
        <pc:picChg chg="add mod topLvl">
          <ac:chgData name="Anja Bronnert" userId="b052a95c-f3aa-4b3c-9053-3af86ea72be5" providerId="ADAL" clId="{61264442-212D-406E-BAB8-6052A94FD241}" dt="2024-03-15T02:53:10.037" v="1314" actId="1076"/>
          <ac:picMkLst>
            <pc:docMk/>
            <pc:sldMk cId="3857424100" sldId="257"/>
            <ac:picMk id="47" creationId="{7D85B45E-39A6-28BE-9C57-9778F82A6F56}"/>
          </ac:picMkLst>
        </pc:picChg>
        <pc:picChg chg="add del mod topLvl">
          <ac:chgData name="Anja Bronnert" userId="b052a95c-f3aa-4b3c-9053-3af86ea72be5" providerId="ADAL" clId="{61264442-212D-406E-BAB8-6052A94FD241}" dt="2024-03-15T02:49:37.347" v="568" actId="21"/>
          <ac:picMkLst>
            <pc:docMk/>
            <pc:sldMk cId="3857424100" sldId="257"/>
            <ac:picMk id="51" creationId="{27F857D9-6288-1DDC-0925-02136FD6A7BF}"/>
          </ac:picMkLst>
        </pc:picChg>
        <pc:picChg chg="add del mod topLvl">
          <ac:chgData name="Anja Bronnert" userId="b052a95c-f3aa-4b3c-9053-3af86ea72be5" providerId="ADAL" clId="{61264442-212D-406E-BAB8-6052A94FD241}" dt="2024-03-15T02:49:37.347" v="568" actId="21"/>
          <ac:picMkLst>
            <pc:docMk/>
            <pc:sldMk cId="3857424100" sldId="257"/>
            <ac:picMk id="53" creationId="{FCBEE3D7-D84F-9206-3F64-FB4F03ED6D17}"/>
          </ac:picMkLst>
        </pc:picChg>
        <pc:picChg chg="add del mod topLvl">
          <ac:chgData name="Anja Bronnert" userId="b052a95c-f3aa-4b3c-9053-3af86ea72be5" providerId="ADAL" clId="{61264442-212D-406E-BAB8-6052A94FD241}" dt="2024-03-15T02:49:37.347" v="568" actId="21"/>
          <ac:picMkLst>
            <pc:docMk/>
            <pc:sldMk cId="3857424100" sldId="257"/>
            <ac:picMk id="69" creationId="{5DF73FB9-275D-9314-5210-2FC7105BFD3E}"/>
          </ac:picMkLst>
        </pc:picChg>
        <pc:picChg chg="add del mod topLvl">
          <ac:chgData name="Anja Bronnert" userId="b052a95c-f3aa-4b3c-9053-3af86ea72be5" providerId="ADAL" clId="{61264442-212D-406E-BAB8-6052A94FD241}" dt="2024-03-15T02:49:37.347" v="568" actId="21"/>
          <ac:picMkLst>
            <pc:docMk/>
            <pc:sldMk cId="3857424100" sldId="257"/>
            <ac:picMk id="73" creationId="{CA7E505A-75B6-BA94-7909-5B009628D15E}"/>
          </ac:picMkLst>
        </pc:picChg>
        <pc:picChg chg="add mod topLvl">
          <ac:chgData name="Anja Bronnert" userId="b052a95c-f3aa-4b3c-9053-3af86ea72be5" providerId="ADAL" clId="{61264442-212D-406E-BAB8-6052A94FD241}" dt="2024-03-15T02:51:08.812" v="1299" actId="1076"/>
          <ac:picMkLst>
            <pc:docMk/>
            <pc:sldMk cId="3857424100" sldId="257"/>
            <ac:picMk id="79" creationId="{5EF6F285-7103-541B-858C-703798AAF65A}"/>
          </ac:picMkLst>
        </pc:picChg>
        <pc:picChg chg="add mod topLvl">
          <ac:chgData name="Anja Bronnert" userId="b052a95c-f3aa-4b3c-9053-3af86ea72be5" providerId="ADAL" clId="{61264442-212D-406E-BAB8-6052A94FD241}" dt="2024-03-15T02:51:38.429" v="1304" actId="1076"/>
          <ac:picMkLst>
            <pc:docMk/>
            <pc:sldMk cId="3857424100" sldId="257"/>
            <ac:picMk id="86" creationId="{23D9D9EE-98D2-DE07-9024-29C51927CCEF}"/>
          </ac:picMkLst>
        </pc:picChg>
      </pc:sldChg>
      <pc:sldChg chg="addSp modSp add mod">
        <pc:chgData name="Anja Bronnert" userId="b052a95c-f3aa-4b3c-9053-3af86ea72be5" providerId="ADAL" clId="{61264442-212D-406E-BAB8-6052A94FD241}" dt="2024-03-15T03:09:36.372" v="2340" actId="1076"/>
        <pc:sldMkLst>
          <pc:docMk/>
          <pc:sldMk cId="3610064377" sldId="258"/>
        </pc:sldMkLst>
        <pc:spChg chg="add mod">
          <ac:chgData name="Anja Bronnert" userId="b052a95c-f3aa-4b3c-9053-3af86ea72be5" providerId="ADAL" clId="{61264442-212D-406E-BAB8-6052A94FD241}" dt="2024-03-15T03:09:29.836" v="2339" actId="404"/>
          <ac:spMkLst>
            <pc:docMk/>
            <pc:sldMk cId="3610064377" sldId="258"/>
            <ac:spMk id="39" creationId="{FB502D71-6217-21AD-CB9A-2E79815129FB}"/>
          </ac:spMkLst>
        </pc:spChg>
        <pc:picChg chg="add mod">
          <ac:chgData name="Anja Bronnert" userId="b052a95c-f3aa-4b3c-9053-3af86ea72be5" providerId="ADAL" clId="{61264442-212D-406E-BAB8-6052A94FD241}" dt="2024-03-15T03:09:36.372" v="2340" actId="1076"/>
          <ac:picMkLst>
            <pc:docMk/>
            <pc:sldMk cId="3610064377" sldId="258"/>
            <ac:picMk id="38" creationId="{37C77D4F-7150-E87B-8C21-E3F1BF670A65}"/>
          </ac:picMkLst>
        </pc:picChg>
      </pc:sldChg>
      <pc:sldChg chg="addSp modSp add mod">
        <pc:chgData name="Anja Bronnert" userId="b052a95c-f3aa-4b3c-9053-3af86ea72be5" providerId="ADAL" clId="{61264442-212D-406E-BAB8-6052A94FD241}" dt="2024-03-15T02:59:20.669" v="1967" actId="1035"/>
        <pc:sldMkLst>
          <pc:docMk/>
          <pc:sldMk cId="2542151272" sldId="259"/>
        </pc:sldMkLst>
        <pc:spChg chg="add mod">
          <ac:chgData name="Anja Bronnert" userId="b052a95c-f3aa-4b3c-9053-3af86ea72be5" providerId="ADAL" clId="{61264442-212D-406E-BAB8-6052A94FD241}" dt="2024-03-15T02:59:20.669" v="1967" actId="1035"/>
          <ac:spMkLst>
            <pc:docMk/>
            <pc:sldMk cId="2542151272" sldId="259"/>
            <ac:spMk id="40" creationId="{EC4BFA1F-3BE3-7028-CA7A-B7C553A0AFAE}"/>
          </ac:spMkLst>
        </pc:spChg>
        <pc:spChg chg="add mod">
          <ac:chgData name="Anja Bronnert" userId="b052a95c-f3aa-4b3c-9053-3af86ea72be5" providerId="ADAL" clId="{61264442-212D-406E-BAB8-6052A94FD241}" dt="2024-03-15T02:59:20.669" v="1967" actId="1035"/>
          <ac:spMkLst>
            <pc:docMk/>
            <pc:sldMk cId="2542151272" sldId="259"/>
            <ac:spMk id="43" creationId="{386318B0-8D50-CCE1-B2FF-00E17BEF008D}"/>
          </ac:spMkLst>
        </pc:spChg>
        <pc:spChg chg="add mod">
          <ac:chgData name="Anja Bronnert" userId="b052a95c-f3aa-4b3c-9053-3af86ea72be5" providerId="ADAL" clId="{61264442-212D-406E-BAB8-6052A94FD241}" dt="2024-03-15T02:59:20.669" v="1967" actId="1035"/>
          <ac:spMkLst>
            <pc:docMk/>
            <pc:sldMk cId="2542151272" sldId="259"/>
            <ac:spMk id="44" creationId="{AAA33D69-54B8-F685-4D27-77FCA1A6F304}"/>
          </ac:spMkLst>
        </pc:spChg>
        <pc:spChg chg="add mod">
          <ac:chgData name="Anja Bronnert" userId="b052a95c-f3aa-4b3c-9053-3af86ea72be5" providerId="ADAL" clId="{61264442-212D-406E-BAB8-6052A94FD241}" dt="2024-03-15T02:59:20.669" v="1967" actId="1035"/>
          <ac:spMkLst>
            <pc:docMk/>
            <pc:sldMk cId="2542151272" sldId="259"/>
            <ac:spMk id="45" creationId="{083E567D-35E2-861D-7188-C90EA2A4E12C}"/>
          </ac:spMkLst>
        </pc:spChg>
        <pc:spChg chg="add mod">
          <ac:chgData name="Anja Bronnert" userId="b052a95c-f3aa-4b3c-9053-3af86ea72be5" providerId="ADAL" clId="{61264442-212D-406E-BAB8-6052A94FD241}" dt="2024-03-15T02:59:20.669" v="1967" actId="1035"/>
          <ac:spMkLst>
            <pc:docMk/>
            <pc:sldMk cId="2542151272" sldId="259"/>
            <ac:spMk id="46" creationId="{E0E40BE0-6E54-875E-27C2-B35D363504E4}"/>
          </ac:spMkLst>
        </pc:spChg>
        <pc:picChg chg="add mod">
          <ac:chgData name="Anja Bronnert" userId="b052a95c-f3aa-4b3c-9053-3af86ea72be5" providerId="ADAL" clId="{61264442-212D-406E-BAB8-6052A94FD241}" dt="2024-03-15T02:59:20.669" v="1967" actId="1035"/>
          <ac:picMkLst>
            <pc:docMk/>
            <pc:sldMk cId="2542151272" sldId="259"/>
            <ac:picMk id="42" creationId="{6D464268-406E-979B-817D-789A3CAB96FE}"/>
          </ac:picMkLst>
        </pc:picChg>
        <pc:picChg chg="add mod">
          <ac:chgData name="Anja Bronnert" userId="b052a95c-f3aa-4b3c-9053-3af86ea72be5" providerId="ADAL" clId="{61264442-212D-406E-BAB8-6052A94FD241}" dt="2024-03-15T02:59:20.669" v="1967" actId="1035"/>
          <ac:picMkLst>
            <pc:docMk/>
            <pc:sldMk cId="2542151272" sldId="259"/>
            <ac:picMk id="48" creationId="{52161B3E-7EE0-DEE2-89F2-E2250E7E95B0}"/>
          </ac:picMkLst>
        </pc:picChg>
        <pc:picChg chg="add mod">
          <ac:chgData name="Anja Bronnert" userId="b052a95c-f3aa-4b3c-9053-3af86ea72be5" providerId="ADAL" clId="{61264442-212D-406E-BAB8-6052A94FD241}" dt="2024-03-15T02:59:20.669" v="1967" actId="1035"/>
          <ac:picMkLst>
            <pc:docMk/>
            <pc:sldMk cId="2542151272" sldId="259"/>
            <ac:picMk id="50" creationId="{17C6BEE7-8D7F-DB5F-2B24-BC0361AAC7B1}"/>
          </ac:picMkLst>
        </pc:picChg>
        <pc:picChg chg="add mod">
          <ac:chgData name="Anja Bronnert" userId="b052a95c-f3aa-4b3c-9053-3af86ea72be5" providerId="ADAL" clId="{61264442-212D-406E-BAB8-6052A94FD241}" dt="2024-03-15T02:59:20.669" v="1967" actId="1035"/>
          <ac:picMkLst>
            <pc:docMk/>
            <pc:sldMk cId="2542151272" sldId="259"/>
            <ac:picMk id="54" creationId="{A5E53B9A-AADB-9DA4-0903-09E6CF60E344}"/>
          </ac:picMkLst>
        </pc:picChg>
        <pc:picChg chg="add mod">
          <ac:chgData name="Anja Bronnert" userId="b052a95c-f3aa-4b3c-9053-3af86ea72be5" providerId="ADAL" clId="{61264442-212D-406E-BAB8-6052A94FD241}" dt="2024-03-15T02:59:20.669" v="1967" actId="1035"/>
          <ac:picMkLst>
            <pc:docMk/>
            <pc:sldMk cId="2542151272" sldId="259"/>
            <ac:picMk id="56" creationId="{7F581DE2-CB37-F01F-E9B1-E69D5D2AED66}"/>
          </ac:picMkLst>
        </pc:picChg>
      </pc:sldChg>
      <pc:sldChg chg="addSp delSp modSp add mod">
        <pc:chgData name="Anja Bronnert" userId="b052a95c-f3aa-4b3c-9053-3af86ea72be5" providerId="ADAL" clId="{61264442-212D-406E-BAB8-6052A94FD241}" dt="2024-03-15T03:02:23.450" v="2007" actId="1076"/>
        <pc:sldMkLst>
          <pc:docMk/>
          <pc:sldMk cId="8744507" sldId="260"/>
        </pc:sldMkLst>
        <pc:spChg chg="add mod">
          <ac:chgData name="Anja Bronnert" userId="b052a95c-f3aa-4b3c-9053-3af86ea72be5" providerId="ADAL" clId="{61264442-212D-406E-BAB8-6052A94FD241}" dt="2024-03-15T03:02:23.450" v="2007" actId="1076"/>
          <ac:spMkLst>
            <pc:docMk/>
            <pc:sldMk cId="8744507" sldId="260"/>
            <ac:spMk id="3" creationId="{01DBE269-231F-9147-9EE2-4C78EE25586C}"/>
          </ac:spMkLst>
        </pc:spChg>
        <pc:spChg chg="add mod topLvl">
          <ac:chgData name="Anja Bronnert" userId="b052a95c-f3aa-4b3c-9053-3af86ea72be5" providerId="ADAL" clId="{61264442-212D-406E-BAB8-6052A94FD241}" dt="2024-03-15T03:01:13.248" v="1992" actId="1076"/>
          <ac:spMkLst>
            <pc:docMk/>
            <pc:sldMk cId="8744507" sldId="260"/>
            <ac:spMk id="57" creationId="{8AA60919-5649-7340-EA83-6E1DB7B0727E}"/>
          </ac:spMkLst>
        </pc:spChg>
        <pc:spChg chg="add mod topLvl">
          <ac:chgData name="Anja Bronnert" userId="b052a95c-f3aa-4b3c-9053-3af86ea72be5" providerId="ADAL" clId="{61264442-212D-406E-BAB8-6052A94FD241}" dt="2024-03-15T03:02:02.382" v="2002" actId="1076"/>
          <ac:spMkLst>
            <pc:docMk/>
            <pc:sldMk cId="8744507" sldId="260"/>
            <ac:spMk id="58" creationId="{4C2B6F63-EF80-A589-5B79-DD9B52260CC4}"/>
          </ac:spMkLst>
        </pc:spChg>
        <pc:spChg chg="add mod topLvl">
          <ac:chgData name="Anja Bronnert" userId="b052a95c-f3aa-4b3c-9053-3af86ea72be5" providerId="ADAL" clId="{61264442-212D-406E-BAB8-6052A94FD241}" dt="2024-03-15T03:01:43.128" v="1998" actId="1076"/>
          <ac:spMkLst>
            <pc:docMk/>
            <pc:sldMk cId="8744507" sldId="260"/>
            <ac:spMk id="60" creationId="{14273051-365E-5B49-B3A6-47525D0D35B9}"/>
          </ac:spMkLst>
        </pc:spChg>
        <pc:spChg chg="add mod topLvl">
          <ac:chgData name="Anja Bronnert" userId="b052a95c-f3aa-4b3c-9053-3af86ea72be5" providerId="ADAL" clId="{61264442-212D-406E-BAB8-6052A94FD241}" dt="2024-03-15T03:01:54.151" v="2000" actId="1076"/>
          <ac:spMkLst>
            <pc:docMk/>
            <pc:sldMk cId="8744507" sldId="260"/>
            <ac:spMk id="61" creationId="{4C67B581-276C-13B7-78A6-526CB7E48D1D}"/>
          </ac:spMkLst>
        </pc:spChg>
        <pc:spChg chg="add mod topLvl">
          <ac:chgData name="Anja Bronnert" userId="b052a95c-f3aa-4b3c-9053-3af86ea72be5" providerId="ADAL" clId="{61264442-212D-406E-BAB8-6052A94FD241}" dt="2024-03-15T03:01:25.489" v="1994" actId="1076"/>
          <ac:spMkLst>
            <pc:docMk/>
            <pc:sldMk cId="8744507" sldId="260"/>
            <ac:spMk id="62" creationId="{065852C7-CB42-4087-F0B8-3747C92CC658}"/>
          </ac:spMkLst>
        </pc:spChg>
        <pc:spChg chg="add mod topLvl">
          <ac:chgData name="Anja Bronnert" userId="b052a95c-f3aa-4b3c-9053-3af86ea72be5" providerId="ADAL" clId="{61264442-212D-406E-BAB8-6052A94FD241}" dt="2024-03-15T03:01:36.560" v="1996" actId="1076"/>
          <ac:spMkLst>
            <pc:docMk/>
            <pc:sldMk cId="8744507" sldId="260"/>
            <ac:spMk id="63" creationId="{7ECA9371-ABC9-2BAF-A966-63F27A9C3D31}"/>
          </ac:spMkLst>
        </pc:spChg>
        <pc:spChg chg="add del mod topLvl">
          <ac:chgData name="Anja Bronnert" userId="b052a95c-f3aa-4b3c-9053-3af86ea72be5" providerId="ADAL" clId="{61264442-212D-406E-BAB8-6052A94FD241}" dt="2024-03-15T03:00:42.238" v="1985" actId="21"/>
          <ac:spMkLst>
            <pc:docMk/>
            <pc:sldMk cId="8744507" sldId="260"/>
            <ac:spMk id="64" creationId="{01DBE269-231F-9147-9EE2-4C78EE25586C}"/>
          </ac:spMkLst>
        </pc:spChg>
        <pc:spChg chg="add del mod topLvl">
          <ac:chgData name="Anja Bronnert" userId="b052a95c-f3aa-4b3c-9053-3af86ea72be5" providerId="ADAL" clId="{61264442-212D-406E-BAB8-6052A94FD241}" dt="2024-03-15T03:00:42.238" v="1985" actId="21"/>
          <ac:spMkLst>
            <pc:docMk/>
            <pc:sldMk cId="8744507" sldId="260"/>
            <ac:spMk id="65" creationId="{C030EF31-DCBE-2397-7A41-65858DD135D1}"/>
          </ac:spMkLst>
        </pc:spChg>
        <pc:spChg chg="add del mod topLvl">
          <ac:chgData name="Anja Bronnert" userId="b052a95c-f3aa-4b3c-9053-3af86ea72be5" providerId="ADAL" clId="{61264442-212D-406E-BAB8-6052A94FD241}" dt="2024-03-15T03:00:42.238" v="1985" actId="21"/>
          <ac:spMkLst>
            <pc:docMk/>
            <pc:sldMk cId="8744507" sldId="260"/>
            <ac:spMk id="66" creationId="{CAE02058-29C9-63B1-B1F3-217193872B96}"/>
          </ac:spMkLst>
        </pc:spChg>
        <pc:grpChg chg="add del mod">
          <ac:chgData name="Anja Bronnert" userId="b052a95c-f3aa-4b3c-9053-3af86ea72be5" providerId="ADAL" clId="{61264442-212D-406E-BAB8-6052A94FD241}" dt="2024-03-15T03:00:38.320" v="1984" actId="165"/>
          <ac:grpSpMkLst>
            <pc:docMk/>
            <pc:sldMk cId="8744507" sldId="260"/>
            <ac:grpSpMk id="2" creationId="{9B405790-1DA1-0155-9A20-8B8CA06B64E4}"/>
          </ac:grpSpMkLst>
        </pc:grpChg>
        <pc:picChg chg="add mod">
          <ac:chgData name="Anja Bronnert" userId="b052a95c-f3aa-4b3c-9053-3af86ea72be5" providerId="ADAL" clId="{61264442-212D-406E-BAB8-6052A94FD241}" dt="2024-03-15T03:02:23.450" v="2007" actId="1076"/>
          <ac:picMkLst>
            <pc:docMk/>
            <pc:sldMk cId="8744507" sldId="260"/>
            <ac:picMk id="4" creationId="{34C723CF-E0A0-A061-A0D3-FA85328EC9FB}"/>
          </ac:picMkLst>
        </pc:picChg>
        <pc:picChg chg="add mod topLvl">
          <ac:chgData name="Anja Bronnert" userId="b052a95c-f3aa-4b3c-9053-3af86ea72be5" providerId="ADAL" clId="{61264442-212D-406E-BAB8-6052A94FD241}" dt="2024-03-15T03:01:21.908" v="1993" actId="1076"/>
          <ac:picMkLst>
            <pc:docMk/>
            <pc:sldMk cId="8744507" sldId="260"/>
            <ac:picMk id="68" creationId="{B8841804-BA18-CBC0-D5C9-784247480AC9}"/>
          </ac:picMkLst>
        </pc:picChg>
        <pc:picChg chg="add mod topLvl">
          <ac:chgData name="Anja Bronnert" userId="b052a95c-f3aa-4b3c-9053-3af86ea72be5" providerId="ADAL" clId="{61264442-212D-406E-BAB8-6052A94FD241}" dt="2024-03-15T03:01:30.404" v="1995" actId="1076"/>
          <ac:picMkLst>
            <pc:docMk/>
            <pc:sldMk cId="8744507" sldId="260"/>
            <ac:picMk id="70" creationId="{F70B24B4-B68F-C718-24F0-6C0A40019F95}"/>
          </ac:picMkLst>
        </pc:picChg>
        <pc:picChg chg="add mod topLvl">
          <ac:chgData name="Anja Bronnert" userId="b052a95c-f3aa-4b3c-9053-3af86ea72be5" providerId="ADAL" clId="{61264442-212D-406E-BAB8-6052A94FD241}" dt="2024-03-15T03:01:39.761" v="1997" actId="1076"/>
          <ac:picMkLst>
            <pc:docMk/>
            <pc:sldMk cId="8744507" sldId="260"/>
            <ac:picMk id="72" creationId="{DACDE3D8-D1C3-2E96-BE51-48CC56F42698}"/>
          </ac:picMkLst>
        </pc:picChg>
        <pc:picChg chg="add mod topLvl">
          <ac:chgData name="Anja Bronnert" userId="b052a95c-f3aa-4b3c-9053-3af86ea72be5" providerId="ADAL" clId="{61264442-212D-406E-BAB8-6052A94FD241}" dt="2024-03-15T03:01:47.320" v="1999" actId="1076"/>
          <ac:picMkLst>
            <pc:docMk/>
            <pc:sldMk cId="8744507" sldId="260"/>
            <ac:picMk id="76" creationId="{143201C0-B2DD-FEF8-6A7A-032BB9D779DB}"/>
          </ac:picMkLst>
        </pc:picChg>
        <pc:picChg chg="add mod topLvl">
          <ac:chgData name="Anja Bronnert" userId="b052a95c-f3aa-4b3c-9053-3af86ea72be5" providerId="ADAL" clId="{61264442-212D-406E-BAB8-6052A94FD241}" dt="2024-03-15T03:01:57.761" v="2001" actId="1076"/>
          <ac:picMkLst>
            <pc:docMk/>
            <pc:sldMk cId="8744507" sldId="260"/>
            <ac:picMk id="78" creationId="{F8EEA25C-3C2A-9013-10AF-2321748CAA99}"/>
          </ac:picMkLst>
        </pc:picChg>
        <pc:picChg chg="add mod topLvl">
          <ac:chgData name="Anja Bronnert" userId="b052a95c-f3aa-4b3c-9053-3af86ea72be5" providerId="ADAL" clId="{61264442-212D-406E-BAB8-6052A94FD241}" dt="2024-03-15T03:02:07.908" v="2003" actId="1076"/>
          <ac:picMkLst>
            <pc:docMk/>
            <pc:sldMk cId="8744507" sldId="260"/>
            <ac:picMk id="81" creationId="{808B1C66-38FC-1454-89AE-632C82A0CD66}"/>
          </ac:picMkLst>
        </pc:picChg>
        <pc:picChg chg="add del mod topLvl">
          <ac:chgData name="Anja Bronnert" userId="b052a95c-f3aa-4b3c-9053-3af86ea72be5" providerId="ADAL" clId="{61264442-212D-406E-BAB8-6052A94FD241}" dt="2024-03-15T03:00:42.238" v="1985" actId="21"/>
          <ac:picMkLst>
            <pc:docMk/>
            <pc:sldMk cId="8744507" sldId="260"/>
            <ac:picMk id="83" creationId="{34C723CF-E0A0-A061-A0D3-FA85328EC9FB}"/>
          </ac:picMkLst>
        </pc:picChg>
        <pc:picChg chg="add del mod topLvl">
          <ac:chgData name="Anja Bronnert" userId="b052a95c-f3aa-4b3c-9053-3af86ea72be5" providerId="ADAL" clId="{61264442-212D-406E-BAB8-6052A94FD241}" dt="2024-03-15T03:00:42.238" v="1985" actId="21"/>
          <ac:picMkLst>
            <pc:docMk/>
            <pc:sldMk cId="8744507" sldId="260"/>
            <ac:picMk id="85" creationId="{1FBFA2CA-0E3A-FCA4-2F99-7D2FB28C5285}"/>
          </ac:picMkLst>
        </pc:picChg>
        <pc:picChg chg="add del mod topLvl">
          <ac:chgData name="Anja Bronnert" userId="b052a95c-f3aa-4b3c-9053-3af86ea72be5" providerId="ADAL" clId="{61264442-212D-406E-BAB8-6052A94FD241}" dt="2024-03-15T03:00:42.238" v="1985" actId="21"/>
          <ac:picMkLst>
            <pc:docMk/>
            <pc:sldMk cId="8744507" sldId="260"/>
            <ac:picMk id="87" creationId="{2907FB7A-5ADF-0282-9086-414B08C0744F}"/>
          </ac:picMkLst>
        </pc:picChg>
      </pc:sldChg>
      <pc:sldChg chg="addSp modSp add mod">
        <pc:chgData name="Anja Bronnert" userId="b052a95c-f3aa-4b3c-9053-3af86ea72be5" providerId="ADAL" clId="{61264442-212D-406E-BAB8-6052A94FD241}" dt="2024-03-15T03:04:45.722" v="2337" actId="1076"/>
        <pc:sldMkLst>
          <pc:docMk/>
          <pc:sldMk cId="2387879109" sldId="261"/>
        </pc:sldMkLst>
        <pc:spChg chg="add mod">
          <ac:chgData name="Anja Bronnert" userId="b052a95c-f3aa-4b3c-9053-3af86ea72be5" providerId="ADAL" clId="{61264442-212D-406E-BAB8-6052A94FD241}" dt="2024-03-15T03:04:17.187" v="2330" actId="1076"/>
          <ac:spMkLst>
            <pc:docMk/>
            <pc:sldMk cId="2387879109" sldId="261"/>
            <ac:spMk id="88" creationId="{556FCC52-795A-E545-637D-D3CDA92C5D76}"/>
          </ac:spMkLst>
        </pc:spChg>
        <pc:spChg chg="add mod">
          <ac:chgData name="Anja Bronnert" userId="b052a95c-f3aa-4b3c-9053-3af86ea72be5" providerId="ADAL" clId="{61264442-212D-406E-BAB8-6052A94FD241}" dt="2024-03-15T03:04:42.813" v="2336" actId="1076"/>
          <ac:spMkLst>
            <pc:docMk/>
            <pc:sldMk cId="2387879109" sldId="261"/>
            <ac:spMk id="89" creationId="{566B8940-AC7D-3B4E-C7E5-E8B5FBA8DAAD}"/>
          </ac:spMkLst>
        </pc:spChg>
        <pc:spChg chg="add mod">
          <ac:chgData name="Anja Bronnert" userId="b052a95c-f3aa-4b3c-9053-3af86ea72be5" providerId="ADAL" clId="{61264442-212D-406E-BAB8-6052A94FD241}" dt="2024-03-15T03:04:27.976" v="2333" actId="14100"/>
          <ac:spMkLst>
            <pc:docMk/>
            <pc:sldMk cId="2387879109" sldId="261"/>
            <ac:spMk id="90" creationId="{997789E9-272D-3019-568D-055FF70243DD}"/>
          </ac:spMkLst>
        </pc:spChg>
        <pc:picChg chg="add mod">
          <ac:chgData name="Anja Bronnert" userId="b052a95c-f3aa-4b3c-9053-3af86ea72be5" providerId="ADAL" clId="{61264442-212D-406E-BAB8-6052A94FD241}" dt="2024-03-15T03:04:21.265" v="2331" actId="1076"/>
          <ac:picMkLst>
            <pc:docMk/>
            <pc:sldMk cId="2387879109" sldId="261"/>
            <ac:picMk id="98" creationId="{28DA7894-9FEF-C4AB-6D35-2219BD0BD432}"/>
          </ac:picMkLst>
        </pc:picChg>
        <pc:picChg chg="add mod">
          <ac:chgData name="Anja Bronnert" userId="b052a95c-f3aa-4b3c-9053-3af86ea72be5" providerId="ADAL" clId="{61264442-212D-406E-BAB8-6052A94FD241}" dt="2024-03-15T03:04:32.906" v="2334" actId="1076"/>
          <ac:picMkLst>
            <pc:docMk/>
            <pc:sldMk cId="2387879109" sldId="261"/>
            <ac:picMk id="100" creationId="{121150F1-539E-A7D5-652E-E783BC54244F}"/>
          </ac:picMkLst>
        </pc:picChg>
        <pc:picChg chg="add mod">
          <ac:chgData name="Anja Bronnert" userId="b052a95c-f3aa-4b3c-9053-3af86ea72be5" providerId="ADAL" clId="{61264442-212D-406E-BAB8-6052A94FD241}" dt="2024-03-15T03:04:45.722" v="2337" actId="1076"/>
          <ac:picMkLst>
            <pc:docMk/>
            <pc:sldMk cId="2387879109" sldId="261"/>
            <ac:picMk id="102" creationId="{5B280C59-606F-45AA-FF9B-7F99051EDE58}"/>
          </ac:picMkLst>
        </pc:picChg>
      </pc:sldChg>
      <pc:sldChg chg="addSp delSp modSp new mod">
        <pc:chgData name="Anja Bronnert" userId="b052a95c-f3aa-4b3c-9053-3af86ea72be5" providerId="ADAL" clId="{61264442-212D-406E-BAB8-6052A94FD241}" dt="2024-03-15T02:55:48.990" v="1612" actId="1076"/>
        <pc:sldMkLst>
          <pc:docMk/>
          <pc:sldMk cId="2788725171" sldId="262"/>
        </pc:sldMkLst>
        <pc:spChg chg="del">
          <ac:chgData name="Anja Bronnert" userId="b052a95c-f3aa-4b3c-9053-3af86ea72be5" providerId="ADAL" clId="{61264442-212D-406E-BAB8-6052A94FD241}" dt="2024-03-15T02:49:19.187" v="565" actId="478"/>
          <ac:spMkLst>
            <pc:docMk/>
            <pc:sldMk cId="2788725171" sldId="262"/>
            <ac:spMk id="2" creationId="{12E6CAC7-86D7-54C2-BF70-BD0F7BF135E2}"/>
          </ac:spMkLst>
        </pc:spChg>
        <pc:spChg chg="del">
          <ac:chgData name="Anja Bronnert" userId="b052a95c-f3aa-4b3c-9053-3af86ea72be5" providerId="ADAL" clId="{61264442-212D-406E-BAB8-6052A94FD241}" dt="2024-03-15T02:49:20.222" v="566" actId="478"/>
          <ac:spMkLst>
            <pc:docMk/>
            <pc:sldMk cId="2788725171" sldId="262"/>
            <ac:spMk id="3" creationId="{A6817017-9BED-75FF-4EA7-B1CFF32E66D1}"/>
          </ac:spMkLst>
        </pc:spChg>
        <pc:spChg chg="add del mod">
          <ac:chgData name="Anja Bronnert" userId="b052a95c-f3aa-4b3c-9053-3af86ea72be5" providerId="ADAL" clId="{61264442-212D-406E-BAB8-6052A94FD241}" dt="2024-03-15T02:53:28.216" v="1347" actId="21"/>
          <ac:spMkLst>
            <pc:docMk/>
            <pc:sldMk cId="2788725171" sldId="262"/>
            <ac:spMk id="6" creationId="{22FC4D48-C251-548F-54C9-7014349674AB}"/>
          </ac:spMkLst>
        </pc:spChg>
        <pc:spChg chg="add mod">
          <ac:chgData name="Anja Bronnert" userId="b052a95c-f3aa-4b3c-9053-3af86ea72be5" providerId="ADAL" clId="{61264442-212D-406E-BAB8-6052A94FD241}" dt="2024-03-15T02:55:41.438" v="1611" actId="1076"/>
          <ac:spMkLst>
            <pc:docMk/>
            <pc:sldMk cId="2788725171" sldId="262"/>
            <ac:spMk id="11" creationId="{75BCAC6D-DAC6-F49D-0D26-C0DDBA603BFE}"/>
          </ac:spMkLst>
        </pc:spChg>
        <pc:spChg chg="add mod">
          <ac:chgData name="Anja Bronnert" userId="b052a95c-f3aa-4b3c-9053-3af86ea72be5" providerId="ADAL" clId="{61264442-212D-406E-BAB8-6052A94FD241}" dt="2024-03-15T02:55:13.652" v="1605" actId="1076"/>
          <ac:spMkLst>
            <pc:docMk/>
            <pc:sldMk cId="2788725171" sldId="262"/>
            <ac:spMk id="13" creationId="{1DE4F0DA-D9D1-C604-6A42-C8CB2AFE3196}"/>
          </ac:spMkLst>
        </pc:spChg>
        <pc:spChg chg="add mod">
          <ac:chgData name="Anja Bronnert" userId="b052a95c-f3aa-4b3c-9053-3af86ea72be5" providerId="ADAL" clId="{61264442-212D-406E-BAB8-6052A94FD241}" dt="2024-03-15T02:54:54.360" v="1602" actId="1076"/>
          <ac:spMkLst>
            <pc:docMk/>
            <pc:sldMk cId="2788725171" sldId="262"/>
            <ac:spMk id="15" creationId="{40573375-4223-C03D-4C1F-57F5DAD3405E}"/>
          </ac:spMkLst>
        </pc:spChg>
        <pc:spChg chg="add mod">
          <ac:chgData name="Anja Bronnert" userId="b052a95c-f3aa-4b3c-9053-3af86ea72be5" providerId="ADAL" clId="{61264442-212D-406E-BAB8-6052A94FD241}" dt="2024-03-15T02:55:22.103" v="1608" actId="1076"/>
          <ac:spMkLst>
            <pc:docMk/>
            <pc:sldMk cId="2788725171" sldId="262"/>
            <ac:spMk id="34" creationId="{75A6ABB3-69C7-5EAB-4D1C-318B9582FE6B}"/>
          </ac:spMkLst>
        </pc:spChg>
        <pc:picChg chg="add mod">
          <ac:chgData name="Anja Bronnert" userId="b052a95c-f3aa-4b3c-9053-3af86ea72be5" providerId="ADAL" clId="{61264442-212D-406E-BAB8-6052A94FD241}" dt="2024-03-15T02:55:36.836" v="1610" actId="1076"/>
          <ac:picMkLst>
            <pc:docMk/>
            <pc:sldMk cId="2788725171" sldId="262"/>
            <ac:picMk id="36" creationId="{998A302D-417B-A7F2-F5DF-DD1F2ADD6234}"/>
          </ac:picMkLst>
        </pc:picChg>
        <pc:picChg chg="add del mod">
          <ac:chgData name="Anja Bronnert" userId="b052a95c-f3aa-4b3c-9053-3af86ea72be5" providerId="ADAL" clId="{61264442-212D-406E-BAB8-6052A94FD241}" dt="2024-03-15T02:53:28.216" v="1347" actId="21"/>
          <ac:picMkLst>
            <pc:docMk/>
            <pc:sldMk cId="2788725171" sldId="262"/>
            <ac:picMk id="51" creationId="{27F857D9-6288-1DDC-0925-02136FD6A7BF}"/>
          </ac:picMkLst>
        </pc:picChg>
        <pc:picChg chg="add mod">
          <ac:chgData name="Anja Bronnert" userId="b052a95c-f3aa-4b3c-9053-3af86ea72be5" providerId="ADAL" clId="{61264442-212D-406E-BAB8-6052A94FD241}" dt="2024-03-15T02:54:57.961" v="1603" actId="1076"/>
          <ac:picMkLst>
            <pc:docMk/>
            <pc:sldMk cId="2788725171" sldId="262"/>
            <ac:picMk id="53" creationId="{FCBEE3D7-D84F-9206-3F64-FB4F03ED6D17}"/>
          </ac:picMkLst>
        </pc:picChg>
        <pc:picChg chg="add mod">
          <ac:chgData name="Anja Bronnert" userId="b052a95c-f3aa-4b3c-9053-3af86ea72be5" providerId="ADAL" clId="{61264442-212D-406E-BAB8-6052A94FD241}" dt="2024-03-15T02:55:17.708" v="1607" actId="1076"/>
          <ac:picMkLst>
            <pc:docMk/>
            <pc:sldMk cId="2788725171" sldId="262"/>
            <ac:picMk id="69" creationId="{5DF73FB9-275D-9314-5210-2FC7105BFD3E}"/>
          </ac:picMkLst>
        </pc:picChg>
        <pc:picChg chg="add mod">
          <ac:chgData name="Anja Bronnert" userId="b052a95c-f3aa-4b3c-9053-3af86ea72be5" providerId="ADAL" clId="{61264442-212D-406E-BAB8-6052A94FD241}" dt="2024-03-15T02:55:48.990" v="1612" actId="1076"/>
          <ac:picMkLst>
            <pc:docMk/>
            <pc:sldMk cId="2788725171" sldId="262"/>
            <ac:picMk id="73" creationId="{CA7E505A-75B6-BA94-7909-5B009628D15E}"/>
          </ac:picMkLst>
        </pc:picChg>
      </pc:sldChg>
      <pc:sldChg chg="addSp delSp modSp new mod">
        <pc:chgData name="Anja Bronnert" userId="b052a95c-f3aa-4b3c-9053-3af86ea72be5" providerId="ADAL" clId="{61264442-212D-406E-BAB8-6052A94FD241}" dt="2024-03-15T03:02:47.730" v="2014" actId="1076"/>
        <pc:sldMkLst>
          <pc:docMk/>
          <pc:sldMk cId="711263433" sldId="263"/>
        </pc:sldMkLst>
        <pc:spChg chg="del">
          <ac:chgData name="Anja Bronnert" userId="b052a95c-f3aa-4b3c-9053-3af86ea72be5" providerId="ADAL" clId="{61264442-212D-406E-BAB8-6052A94FD241}" dt="2024-03-15T03:00:48.252" v="1989" actId="478"/>
          <ac:spMkLst>
            <pc:docMk/>
            <pc:sldMk cId="711263433" sldId="263"/>
            <ac:spMk id="2" creationId="{2021F747-88BB-38EC-062F-BB47F3EF972C}"/>
          </ac:spMkLst>
        </pc:spChg>
        <pc:spChg chg="del">
          <ac:chgData name="Anja Bronnert" userId="b052a95c-f3aa-4b3c-9053-3af86ea72be5" providerId="ADAL" clId="{61264442-212D-406E-BAB8-6052A94FD241}" dt="2024-03-15T03:00:47.042" v="1988" actId="478"/>
          <ac:spMkLst>
            <pc:docMk/>
            <pc:sldMk cId="711263433" sldId="263"/>
            <ac:spMk id="3" creationId="{E2CDD45F-6841-199A-47E3-96E87C306A4A}"/>
          </ac:spMkLst>
        </pc:spChg>
        <pc:spChg chg="add del mod">
          <ac:chgData name="Anja Bronnert" userId="b052a95c-f3aa-4b3c-9053-3af86ea72be5" providerId="ADAL" clId="{61264442-212D-406E-BAB8-6052A94FD241}" dt="2024-03-15T03:02:31.307" v="2009" actId="1076"/>
          <ac:spMkLst>
            <pc:docMk/>
            <pc:sldMk cId="711263433" sldId="263"/>
            <ac:spMk id="64" creationId="{01DBE269-231F-9147-9EE2-4C78EE25586C}"/>
          </ac:spMkLst>
        </pc:spChg>
        <pc:spChg chg="add mod">
          <ac:chgData name="Anja Bronnert" userId="b052a95c-f3aa-4b3c-9053-3af86ea72be5" providerId="ADAL" clId="{61264442-212D-406E-BAB8-6052A94FD241}" dt="2024-03-15T03:02:41.250" v="2011" actId="1076"/>
          <ac:spMkLst>
            <pc:docMk/>
            <pc:sldMk cId="711263433" sldId="263"/>
            <ac:spMk id="65" creationId="{C030EF31-DCBE-2397-7A41-65858DD135D1}"/>
          </ac:spMkLst>
        </pc:spChg>
        <pc:spChg chg="add mod">
          <ac:chgData name="Anja Bronnert" userId="b052a95c-f3aa-4b3c-9053-3af86ea72be5" providerId="ADAL" clId="{61264442-212D-406E-BAB8-6052A94FD241}" dt="2024-03-15T03:02:45.842" v="2013" actId="1076"/>
          <ac:spMkLst>
            <pc:docMk/>
            <pc:sldMk cId="711263433" sldId="263"/>
            <ac:spMk id="66" creationId="{CAE02058-29C9-63B1-B1F3-217193872B96}"/>
          </ac:spMkLst>
        </pc:spChg>
        <pc:picChg chg="add del mod">
          <ac:chgData name="Anja Bronnert" userId="b052a95c-f3aa-4b3c-9053-3af86ea72be5" providerId="ADAL" clId="{61264442-212D-406E-BAB8-6052A94FD241}" dt="2024-03-15T03:02:39.115" v="2010" actId="1076"/>
          <ac:picMkLst>
            <pc:docMk/>
            <pc:sldMk cId="711263433" sldId="263"/>
            <ac:picMk id="83" creationId="{34C723CF-E0A0-A061-A0D3-FA85328EC9FB}"/>
          </ac:picMkLst>
        </pc:picChg>
        <pc:picChg chg="add mod">
          <ac:chgData name="Anja Bronnert" userId="b052a95c-f3aa-4b3c-9053-3af86ea72be5" providerId="ADAL" clId="{61264442-212D-406E-BAB8-6052A94FD241}" dt="2024-03-15T03:02:43.206" v="2012" actId="1076"/>
          <ac:picMkLst>
            <pc:docMk/>
            <pc:sldMk cId="711263433" sldId="263"/>
            <ac:picMk id="85" creationId="{1FBFA2CA-0E3A-FCA4-2F99-7D2FB28C5285}"/>
          </ac:picMkLst>
        </pc:picChg>
        <pc:picChg chg="add mod">
          <ac:chgData name="Anja Bronnert" userId="b052a95c-f3aa-4b3c-9053-3af86ea72be5" providerId="ADAL" clId="{61264442-212D-406E-BAB8-6052A94FD241}" dt="2024-03-15T03:02:47.730" v="2014" actId="1076"/>
          <ac:picMkLst>
            <pc:docMk/>
            <pc:sldMk cId="711263433" sldId="263"/>
            <ac:picMk id="87" creationId="{2907FB7A-5ADF-0282-9086-414B08C0744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33951" y="3499590"/>
            <a:ext cx="12851448" cy="7444669"/>
          </a:xfrm>
        </p:spPr>
        <p:txBody>
          <a:bodyPr anchor="b"/>
          <a:lstStyle>
            <a:lvl1pPr algn="ctr">
              <a:defRPr sz="992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89919" y="11231355"/>
            <a:ext cx="11339513" cy="5162758"/>
          </a:xfrm>
        </p:spPr>
        <p:txBody>
          <a:bodyPr/>
          <a:lstStyle>
            <a:lvl1pPr marL="0" indent="0" algn="ctr">
              <a:buNone/>
              <a:defRPr sz="3968"/>
            </a:lvl1pPr>
            <a:lvl2pPr marL="755980" indent="0" algn="ctr">
              <a:buNone/>
              <a:defRPr sz="3307"/>
            </a:lvl2pPr>
            <a:lvl3pPr marL="1511960" indent="0" algn="ctr">
              <a:buNone/>
              <a:defRPr sz="2976"/>
            </a:lvl3pPr>
            <a:lvl4pPr marL="2267941" indent="0" algn="ctr">
              <a:buNone/>
              <a:defRPr sz="2646"/>
            </a:lvl4pPr>
            <a:lvl5pPr marL="3023921" indent="0" algn="ctr">
              <a:buNone/>
              <a:defRPr sz="2646"/>
            </a:lvl5pPr>
            <a:lvl6pPr marL="3779901" indent="0" algn="ctr">
              <a:buNone/>
              <a:defRPr sz="2646"/>
            </a:lvl6pPr>
            <a:lvl7pPr marL="4535881" indent="0" algn="ctr">
              <a:buNone/>
              <a:defRPr sz="2646"/>
            </a:lvl7pPr>
            <a:lvl8pPr marL="5291861" indent="0" algn="ctr">
              <a:buNone/>
              <a:defRPr sz="2646"/>
            </a:lvl8pPr>
            <a:lvl9pPr marL="6047842" indent="0" algn="ctr">
              <a:buNone/>
              <a:defRPr sz="264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47165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97816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819786" y="1138480"/>
            <a:ext cx="3260110" cy="181216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39456" y="1138480"/>
            <a:ext cx="9591338" cy="181216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18335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50804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1582" y="5331063"/>
            <a:ext cx="13040439" cy="8894992"/>
          </a:xfrm>
        </p:spPr>
        <p:txBody>
          <a:bodyPr anchor="b"/>
          <a:lstStyle>
            <a:lvl1pPr>
              <a:defRPr sz="992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1582" y="14310205"/>
            <a:ext cx="13040439" cy="4677666"/>
          </a:xfrm>
        </p:spPr>
        <p:txBody>
          <a:bodyPr/>
          <a:lstStyle>
            <a:lvl1pPr marL="0" indent="0">
              <a:buNone/>
              <a:defRPr sz="3968">
                <a:solidFill>
                  <a:schemeClr val="tx1">
                    <a:tint val="82000"/>
                  </a:schemeClr>
                </a:solidFill>
              </a:defRPr>
            </a:lvl1pPr>
            <a:lvl2pPr marL="755980" indent="0">
              <a:buNone/>
              <a:defRPr sz="3307">
                <a:solidFill>
                  <a:schemeClr val="tx1">
                    <a:tint val="82000"/>
                  </a:schemeClr>
                </a:solidFill>
              </a:defRPr>
            </a:lvl2pPr>
            <a:lvl3pPr marL="1511960" indent="0">
              <a:buNone/>
              <a:defRPr sz="2976">
                <a:solidFill>
                  <a:schemeClr val="tx1">
                    <a:tint val="82000"/>
                  </a:schemeClr>
                </a:solidFill>
              </a:defRPr>
            </a:lvl3pPr>
            <a:lvl4pPr marL="2267941" indent="0">
              <a:buNone/>
              <a:defRPr sz="2646">
                <a:solidFill>
                  <a:schemeClr val="tx1">
                    <a:tint val="82000"/>
                  </a:schemeClr>
                </a:solidFill>
              </a:defRPr>
            </a:lvl4pPr>
            <a:lvl5pPr marL="3023921" indent="0">
              <a:buNone/>
              <a:defRPr sz="2646">
                <a:solidFill>
                  <a:schemeClr val="tx1">
                    <a:tint val="82000"/>
                  </a:schemeClr>
                </a:solidFill>
              </a:defRPr>
            </a:lvl5pPr>
            <a:lvl6pPr marL="3779901" indent="0">
              <a:buNone/>
              <a:defRPr sz="2646">
                <a:solidFill>
                  <a:schemeClr val="tx1">
                    <a:tint val="82000"/>
                  </a:schemeClr>
                </a:solidFill>
              </a:defRPr>
            </a:lvl6pPr>
            <a:lvl7pPr marL="4535881" indent="0">
              <a:buNone/>
              <a:defRPr sz="2646">
                <a:solidFill>
                  <a:schemeClr val="tx1">
                    <a:tint val="82000"/>
                  </a:schemeClr>
                </a:solidFill>
              </a:defRPr>
            </a:lvl7pPr>
            <a:lvl8pPr marL="5291861" indent="0">
              <a:buNone/>
              <a:defRPr sz="2646">
                <a:solidFill>
                  <a:schemeClr val="tx1">
                    <a:tint val="82000"/>
                  </a:schemeClr>
                </a:solidFill>
              </a:defRPr>
            </a:lvl8pPr>
            <a:lvl9pPr marL="6047842" indent="0">
              <a:buNone/>
              <a:defRPr sz="2646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566801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39455" y="5692400"/>
            <a:ext cx="6425724" cy="135677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54171" y="5692400"/>
            <a:ext cx="6425724" cy="135677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58717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138485"/>
            <a:ext cx="13040439" cy="413317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1426" y="5241960"/>
            <a:ext cx="6396193" cy="2569003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1426" y="7810963"/>
            <a:ext cx="6396193" cy="114887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654172" y="5241960"/>
            <a:ext cx="6427693" cy="2569003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654172" y="7810963"/>
            <a:ext cx="6427693" cy="114887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857970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24242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26231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425575"/>
            <a:ext cx="4876384" cy="4989513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27693" y="3078850"/>
            <a:ext cx="7654171" cy="15196234"/>
          </a:xfrm>
        </p:spPr>
        <p:txBody>
          <a:bodyPr/>
          <a:lstStyle>
            <a:lvl1pPr>
              <a:defRPr sz="5291"/>
            </a:lvl1pPr>
            <a:lvl2pPr>
              <a:defRPr sz="4630"/>
            </a:lvl2pPr>
            <a:lvl3pPr>
              <a:defRPr sz="3968"/>
            </a:lvl3pPr>
            <a:lvl4pPr>
              <a:defRPr sz="3307"/>
            </a:lvl4pPr>
            <a:lvl5pPr>
              <a:defRPr sz="3307"/>
            </a:lvl5pPr>
            <a:lvl6pPr>
              <a:defRPr sz="3307"/>
            </a:lvl6pPr>
            <a:lvl7pPr>
              <a:defRPr sz="3307"/>
            </a:lvl7pPr>
            <a:lvl8pPr>
              <a:defRPr sz="3307"/>
            </a:lvl8pPr>
            <a:lvl9pPr>
              <a:defRPr sz="3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6415088"/>
            <a:ext cx="4876384" cy="11884743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11597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425575"/>
            <a:ext cx="4876384" cy="4989513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427693" y="3078850"/>
            <a:ext cx="7654171" cy="15196234"/>
          </a:xfrm>
        </p:spPr>
        <p:txBody>
          <a:bodyPr anchor="t"/>
          <a:lstStyle>
            <a:lvl1pPr marL="0" indent="0">
              <a:buNone/>
              <a:defRPr sz="5291"/>
            </a:lvl1pPr>
            <a:lvl2pPr marL="755980" indent="0">
              <a:buNone/>
              <a:defRPr sz="4630"/>
            </a:lvl2pPr>
            <a:lvl3pPr marL="1511960" indent="0">
              <a:buNone/>
              <a:defRPr sz="3968"/>
            </a:lvl3pPr>
            <a:lvl4pPr marL="2267941" indent="0">
              <a:buNone/>
              <a:defRPr sz="3307"/>
            </a:lvl4pPr>
            <a:lvl5pPr marL="3023921" indent="0">
              <a:buNone/>
              <a:defRPr sz="3307"/>
            </a:lvl5pPr>
            <a:lvl6pPr marL="3779901" indent="0">
              <a:buNone/>
              <a:defRPr sz="3307"/>
            </a:lvl6pPr>
            <a:lvl7pPr marL="4535881" indent="0">
              <a:buNone/>
              <a:defRPr sz="3307"/>
            </a:lvl7pPr>
            <a:lvl8pPr marL="5291861" indent="0">
              <a:buNone/>
              <a:defRPr sz="3307"/>
            </a:lvl8pPr>
            <a:lvl9pPr marL="6047842" indent="0">
              <a:buNone/>
              <a:defRPr sz="330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6415088"/>
            <a:ext cx="4876384" cy="11884743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27108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39456" y="1138485"/>
            <a:ext cx="13040439" cy="413317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9456" y="5692400"/>
            <a:ext cx="13040439" cy="135677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39455" y="19819457"/>
            <a:ext cx="3401854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8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D3853B9-326A-479E-87D0-E3FF0890F764}" type="datetimeFigureOut">
              <a:rPr lang="en-NZ" smtClean="0"/>
              <a:t>15/03/202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008285" y="19819457"/>
            <a:ext cx="5102781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8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678041" y="19819457"/>
            <a:ext cx="3401854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8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59EA44-1136-4B96-8B8E-DA9979E91FA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28148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511960" rtl="0" eaLnBrk="1" latinLnBrk="0" hangingPunct="1">
        <a:lnSpc>
          <a:spcPct val="90000"/>
        </a:lnSpc>
        <a:spcBef>
          <a:spcPct val="0"/>
        </a:spcBef>
        <a:buNone/>
        <a:defRPr sz="72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7990" indent="-377990" algn="l" defTabSz="1511960" rtl="0" eaLnBrk="1" latinLnBrk="0" hangingPunct="1">
        <a:lnSpc>
          <a:spcPct val="90000"/>
        </a:lnSpc>
        <a:spcBef>
          <a:spcPts val="1654"/>
        </a:spcBef>
        <a:buFont typeface="Arial" panose="020B0604020202020204" pitchFamily="34" charset="0"/>
        <a:buChar char="•"/>
        <a:defRPr sz="4630" kern="1200">
          <a:solidFill>
            <a:schemeClr val="tx1"/>
          </a:solidFill>
          <a:latin typeface="+mn-lt"/>
          <a:ea typeface="+mn-ea"/>
          <a:cs typeface="+mn-cs"/>
        </a:defRPr>
      </a:lvl1pPr>
      <a:lvl2pPr marL="1133970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2pPr>
      <a:lvl3pPr marL="188995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3pPr>
      <a:lvl4pPr marL="264593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40191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415789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91387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66985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42583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1pPr>
      <a:lvl2pPr marL="75598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2pPr>
      <a:lvl3pPr marL="151196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3pPr>
      <a:lvl4pPr marL="226794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02392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377990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53588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29186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047842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sv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svg"/><Relationship Id="rId3" Type="http://schemas.openxmlformats.org/officeDocument/2006/relationships/image" Target="../media/image14.svg"/><Relationship Id="rId7" Type="http://schemas.openxmlformats.org/officeDocument/2006/relationships/image" Target="../media/image18.sv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svg"/><Relationship Id="rId5" Type="http://schemas.openxmlformats.org/officeDocument/2006/relationships/image" Target="../media/image16.sv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sv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svg"/><Relationship Id="rId7" Type="http://schemas.openxmlformats.org/officeDocument/2006/relationships/image" Target="../media/image30.sv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svg"/><Relationship Id="rId4" Type="http://schemas.openxmlformats.org/officeDocument/2006/relationships/image" Target="../media/image27.png"/><Relationship Id="rId9" Type="http://schemas.openxmlformats.org/officeDocument/2006/relationships/image" Target="../media/image32.sv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sv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3" Type="http://schemas.openxmlformats.org/officeDocument/2006/relationships/image" Target="../media/image36.svg"/><Relationship Id="rId7" Type="http://schemas.openxmlformats.org/officeDocument/2006/relationships/image" Target="../media/image40.sv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11" Type="http://schemas.openxmlformats.org/officeDocument/2006/relationships/image" Target="../media/image44.svg"/><Relationship Id="rId5" Type="http://schemas.openxmlformats.org/officeDocument/2006/relationships/image" Target="../media/image38.svg"/><Relationship Id="rId10" Type="http://schemas.openxmlformats.org/officeDocument/2006/relationships/image" Target="../media/image43.png"/><Relationship Id="rId4" Type="http://schemas.openxmlformats.org/officeDocument/2006/relationships/image" Target="../media/image37.png"/><Relationship Id="rId9" Type="http://schemas.openxmlformats.org/officeDocument/2006/relationships/image" Target="../media/image42.sv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13" Type="http://schemas.openxmlformats.org/officeDocument/2006/relationships/image" Target="../media/image56.svg"/><Relationship Id="rId3" Type="http://schemas.openxmlformats.org/officeDocument/2006/relationships/image" Target="../media/image46.svg"/><Relationship Id="rId7" Type="http://schemas.openxmlformats.org/officeDocument/2006/relationships/image" Target="../media/image50.svg"/><Relationship Id="rId12" Type="http://schemas.openxmlformats.org/officeDocument/2006/relationships/image" Target="../media/image55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11" Type="http://schemas.openxmlformats.org/officeDocument/2006/relationships/image" Target="../media/image54.svg"/><Relationship Id="rId5" Type="http://schemas.openxmlformats.org/officeDocument/2006/relationships/image" Target="../media/image48.svg"/><Relationship Id="rId10" Type="http://schemas.openxmlformats.org/officeDocument/2006/relationships/image" Target="../media/image53.png"/><Relationship Id="rId4" Type="http://schemas.openxmlformats.org/officeDocument/2006/relationships/image" Target="../media/image47.png"/><Relationship Id="rId9" Type="http://schemas.openxmlformats.org/officeDocument/2006/relationships/image" Target="../media/image52.sv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svg"/><Relationship Id="rId7" Type="http://schemas.openxmlformats.org/officeDocument/2006/relationships/image" Target="../media/image62.sv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1.png"/><Relationship Id="rId5" Type="http://schemas.openxmlformats.org/officeDocument/2006/relationships/image" Target="../media/image60.svg"/><Relationship Id="rId4" Type="http://schemas.openxmlformats.org/officeDocument/2006/relationships/image" Target="../media/image5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svg"/><Relationship Id="rId7" Type="http://schemas.openxmlformats.org/officeDocument/2006/relationships/image" Target="../media/image68.sv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7.png"/><Relationship Id="rId5" Type="http://schemas.openxmlformats.org/officeDocument/2006/relationships/image" Target="../media/image66.svg"/><Relationship Id="rId4" Type="http://schemas.openxmlformats.org/officeDocument/2006/relationships/image" Target="../media/image6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C8228E25-368A-336F-080D-AF87F7FF1554}"/>
              </a:ext>
            </a:extLst>
          </p:cNvPr>
          <p:cNvGrpSpPr>
            <a:grpSpLocks noChangeAspect="1"/>
          </p:cNvGrpSpPr>
          <p:nvPr/>
        </p:nvGrpSpPr>
        <p:grpSpPr>
          <a:xfrm>
            <a:off x="701675" y="513159"/>
            <a:ext cx="13715999" cy="20357305"/>
            <a:chOff x="-3769075" y="-95775"/>
            <a:chExt cx="7560325" cy="1122104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B094110-23E6-6E85-68CD-771E6130E409}"/>
                </a:ext>
              </a:extLst>
            </p:cNvPr>
            <p:cNvSpPr txBox="1"/>
            <p:nvPr/>
          </p:nvSpPr>
          <p:spPr>
            <a:xfrm>
              <a:off x="-3769075" y="-95775"/>
              <a:ext cx="7560000" cy="525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1 Vitamin A</a:t>
              </a:r>
              <a:endParaRPr lang="en-NZ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1.1 Cognitive impairment, Bayley Mental Development Index &lt;70, at 18-22 months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86C4650-84C6-A7BA-C7AF-7EDC4F606666}"/>
                </a:ext>
              </a:extLst>
            </p:cNvPr>
            <p:cNvSpPr txBox="1"/>
            <p:nvPr/>
          </p:nvSpPr>
          <p:spPr>
            <a:xfrm>
              <a:off x="-3769075" y="1881903"/>
              <a:ext cx="7560001" cy="52590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lvl="1">
                <a:spcAft>
                  <a:spcPts val="600"/>
                </a:spcAft>
              </a:pPr>
              <a:r>
                <a:rPr lang="en-US" sz="2800" kern="100" dirty="0">
                  <a:latin typeface="Arial" panose="020B0604020202020204" pitchFamily="34" charset="0"/>
                  <a:cs typeface="Arial" panose="020B0604020202020204" pitchFamily="34" charset="0"/>
                </a:rPr>
                <a:t>1. 2 Motor impairment, Bayley Psychomotor Developmental Index &lt;70, at 18-22 months</a:t>
              </a:r>
              <a:endParaRPr lang="en-NZ" sz="2800" kern="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C00B5AB-9544-204E-C7EB-B8D492765EF2}"/>
                </a:ext>
              </a:extLst>
            </p:cNvPr>
            <p:cNvSpPr txBox="1"/>
            <p:nvPr/>
          </p:nvSpPr>
          <p:spPr>
            <a:xfrm>
              <a:off x="-3768750" y="3854451"/>
              <a:ext cx="7560000" cy="28840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lvl="1">
                <a:spcAft>
                  <a:spcPts val="600"/>
                </a:spcAft>
              </a:pPr>
              <a:r>
                <a:rPr lang="en-US" sz="2800" kern="100" dirty="0">
                  <a:latin typeface="Arial" panose="020B0604020202020204" pitchFamily="34" charset="0"/>
                  <a:cs typeface="Arial" panose="020B0604020202020204" pitchFamily="34" charset="0"/>
                </a:rPr>
                <a:t>1.3 Blindness in both eyes, at 18-22 months</a:t>
              </a:r>
              <a:endParaRPr lang="en-NZ" sz="2800" kern="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DA9C8CF-C6BA-A327-5836-9293CF5543AC}"/>
                </a:ext>
              </a:extLst>
            </p:cNvPr>
            <p:cNvSpPr txBox="1"/>
            <p:nvPr/>
          </p:nvSpPr>
          <p:spPr>
            <a:xfrm>
              <a:off x="-3769075" y="5667093"/>
              <a:ext cx="7560000" cy="28840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lvl="1">
                <a:spcAft>
                  <a:spcPts val="600"/>
                </a:spcAft>
              </a:pPr>
              <a:r>
                <a:rPr lang="en-US" sz="2800" kern="100" dirty="0">
                  <a:latin typeface="Arial" panose="020B0604020202020204" pitchFamily="34" charset="0"/>
                  <a:cs typeface="Arial" panose="020B0604020202020204" pitchFamily="34" charset="0"/>
                </a:rPr>
                <a:t>1.4 Deafness, defined as hearing aids in both ears, at 18-22 months</a:t>
              </a:r>
              <a:endParaRPr lang="en-NZ" sz="2800" kern="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2D046F6-CDEA-DA25-6C56-C2FAE57E00D4}"/>
                </a:ext>
              </a:extLst>
            </p:cNvPr>
            <p:cNvSpPr txBox="1"/>
            <p:nvPr/>
          </p:nvSpPr>
          <p:spPr>
            <a:xfrm>
              <a:off x="-3769075" y="7485629"/>
              <a:ext cx="7560000" cy="28840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lvl="1">
                <a:spcAft>
                  <a:spcPts val="600"/>
                </a:spcAft>
              </a:pPr>
              <a:r>
                <a:rPr lang="en-US" sz="2800" kern="100" dirty="0">
                  <a:latin typeface="Arial" panose="020B0604020202020204" pitchFamily="34" charset="0"/>
                  <a:cs typeface="Arial" panose="020B0604020202020204" pitchFamily="34" charset="0"/>
                </a:rPr>
                <a:t>1.5 Cerebral Palsy, at 18-22 months</a:t>
              </a:r>
              <a:endParaRPr lang="en-NZ" sz="2800" kern="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" name="Graphic 15">
              <a:extLst>
                <a:ext uri="{FF2B5EF4-FFF2-40B4-BE49-F238E27FC236}">
                  <a16:creationId xmlns:a16="http://schemas.microsoft.com/office/drawing/2014/main" id="{F2A3A1AC-02F8-23F0-E2EB-02E7114BF05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-3769075" y="434243"/>
              <a:ext cx="7560000" cy="1447660"/>
            </a:xfrm>
            <a:prstGeom prst="rect">
              <a:avLst/>
            </a:prstGeom>
          </p:spPr>
        </p:pic>
        <p:pic>
          <p:nvPicPr>
            <p:cNvPr id="18" name="Graphic 17">
              <a:extLst>
                <a:ext uri="{FF2B5EF4-FFF2-40B4-BE49-F238E27FC236}">
                  <a16:creationId xmlns:a16="http://schemas.microsoft.com/office/drawing/2014/main" id="{0CA4DE54-3F97-BF96-7CDD-113BB374A61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-3769075" y="2407811"/>
              <a:ext cx="7560000" cy="1447660"/>
            </a:xfrm>
            <a:prstGeom prst="rect">
              <a:avLst/>
            </a:prstGeom>
          </p:spPr>
        </p:pic>
        <p:pic>
          <p:nvPicPr>
            <p:cNvPr id="20" name="Graphic 19">
              <a:extLst>
                <a:ext uri="{FF2B5EF4-FFF2-40B4-BE49-F238E27FC236}">
                  <a16:creationId xmlns:a16="http://schemas.microsoft.com/office/drawing/2014/main" id="{C1CEA4EF-56E9-C210-A6EA-A25EFD084B5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-3768750" y="4223782"/>
              <a:ext cx="7560000" cy="1443820"/>
            </a:xfrm>
            <a:prstGeom prst="rect">
              <a:avLst/>
            </a:prstGeom>
          </p:spPr>
        </p:pic>
        <p:pic>
          <p:nvPicPr>
            <p:cNvPr id="22" name="Graphic 21">
              <a:extLst>
                <a:ext uri="{FF2B5EF4-FFF2-40B4-BE49-F238E27FC236}">
                  <a16:creationId xmlns:a16="http://schemas.microsoft.com/office/drawing/2014/main" id="{5A400EDE-7667-E2AD-6953-95D75E4D2E5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9"/>
                </a:ext>
              </a:extLst>
            </a:blip>
            <a:stretch>
              <a:fillRect/>
            </a:stretch>
          </p:blipFill>
          <p:spPr>
            <a:xfrm>
              <a:off x="-3768750" y="6035403"/>
              <a:ext cx="7560000" cy="1447660"/>
            </a:xfrm>
            <a:prstGeom prst="rect">
              <a:avLst/>
            </a:prstGeom>
          </p:spPr>
        </p:pic>
        <p:pic>
          <p:nvPicPr>
            <p:cNvPr id="24" name="Graphic 23">
              <a:extLst>
                <a:ext uri="{FF2B5EF4-FFF2-40B4-BE49-F238E27FC236}">
                  <a16:creationId xmlns:a16="http://schemas.microsoft.com/office/drawing/2014/main" id="{118B5BCE-D2C4-A422-00D6-14B3A852404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1"/>
                </a:ext>
              </a:extLst>
            </a:blip>
            <a:stretch>
              <a:fillRect/>
            </a:stretch>
          </p:blipFill>
          <p:spPr>
            <a:xfrm>
              <a:off x="-3768750" y="7856504"/>
              <a:ext cx="7560000" cy="1447660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B2BB0C6-3E8B-A3E8-056A-2C8010517EDC}"/>
                </a:ext>
              </a:extLst>
            </p:cNvPr>
            <p:cNvSpPr txBox="1"/>
            <p:nvPr/>
          </p:nvSpPr>
          <p:spPr>
            <a:xfrm>
              <a:off x="-3768750" y="9308274"/>
              <a:ext cx="7560000" cy="28840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lvl="1">
                <a:spcAft>
                  <a:spcPts val="600"/>
                </a:spcAft>
              </a:pPr>
              <a:r>
                <a:rPr lang="en-US" sz="2800" kern="100" dirty="0">
                  <a:latin typeface="Arial" panose="020B0604020202020204" pitchFamily="34" charset="0"/>
                  <a:cs typeface="Arial" panose="020B0604020202020204" pitchFamily="34" charset="0"/>
                </a:rPr>
                <a:t>1.6 Pulmonary hemorrhage, during initial hospitalization after birth</a:t>
              </a:r>
              <a:endParaRPr lang="en-NZ" sz="2800" kern="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" name="Graphic 26">
              <a:extLst>
                <a:ext uri="{FF2B5EF4-FFF2-40B4-BE49-F238E27FC236}">
                  <a16:creationId xmlns:a16="http://schemas.microsoft.com/office/drawing/2014/main" id="{6C6A8E86-21E6-9126-AA96-6141B5A94A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3"/>
                </a:ext>
              </a:extLst>
            </a:blip>
            <a:stretch>
              <a:fillRect/>
            </a:stretch>
          </p:blipFill>
          <p:spPr>
            <a:xfrm>
              <a:off x="-3769075" y="9677605"/>
              <a:ext cx="7560000" cy="144766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D84F98C6-78A2-8265-E84F-D4D9713198BD}"/>
              </a:ext>
            </a:extLst>
          </p:cNvPr>
          <p:cNvSpPr txBox="1"/>
          <p:nvPr/>
        </p:nvSpPr>
        <p:spPr>
          <a:xfrm>
            <a:off x="1" y="21025085"/>
            <a:ext cx="15119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, confidence interval; IV, inverse variance; </a:t>
            </a:r>
            <a:r>
              <a:rPr lang="en-NZ" sz="1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M-H, Mantel-Haenszel method; </a:t>
            </a:r>
            <a:r>
              <a:rPr lang="en-NZ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, standard care</a:t>
            </a:r>
          </a:p>
        </p:txBody>
      </p:sp>
    </p:spTree>
    <p:extLst>
      <p:ext uri="{BB962C8B-B14F-4D97-AF65-F5344CB8AC3E}">
        <p14:creationId xmlns:p14="http://schemas.microsoft.com/office/powerpoint/2010/main" val="26633847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>
            <a:extLst>
              <a:ext uri="{FF2B5EF4-FFF2-40B4-BE49-F238E27FC236}">
                <a16:creationId xmlns:a16="http://schemas.microsoft.com/office/drawing/2014/main" id="{8843084D-3D21-6EB9-CE1D-5797D2672AB3}"/>
              </a:ext>
            </a:extLst>
          </p:cNvPr>
          <p:cNvSpPr txBox="1"/>
          <p:nvPr/>
        </p:nvSpPr>
        <p:spPr>
          <a:xfrm>
            <a:off x="707949" y="348343"/>
            <a:ext cx="1370649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b="1" dirty="0">
                <a:latin typeface="Arial" panose="020B0604020202020204" pitchFamily="34" charset="0"/>
                <a:cs typeface="Arial" panose="020B0604020202020204" pitchFamily="34" charset="0"/>
              </a:rPr>
              <a:t>2 Vitamin D</a:t>
            </a:r>
            <a:endParaRPr lang="en-NZ" b="1" kern="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2.1 Cognitive impairment, Bayley III cognitive score &lt;85, at 22-26 month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6D20541-1980-D0D3-523D-AD57414BE9EB}"/>
              </a:ext>
            </a:extLst>
          </p:cNvPr>
          <p:cNvSpPr txBox="1"/>
          <p:nvPr/>
        </p:nvSpPr>
        <p:spPr>
          <a:xfrm>
            <a:off x="713649" y="4038810"/>
            <a:ext cx="1371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2.2  </a:t>
            </a:r>
            <a:r>
              <a:rPr lang="en-NZ" sz="28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anguage impairment, Bayley III cognitive score &lt;85, at 22-26 months</a:t>
            </a:r>
            <a:endParaRPr lang="en-NZ" sz="28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F98C436-675B-4A0A-9F4C-7334F500814D}"/>
              </a:ext>
            </a:extLst>
          </p:cNvPr>
          <p:cNvSpPr txBox="1"/>
          <p:nvPr/>
        </p:nvSpPr>
        <p:spPr>
          <a:xfrm>
            <a:off x="707948" y="10602144"/>
            <a:ext cx="13716000" cy="52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.4 Severe retinopathy of prematurity (stage 3 and higher or requiring treatment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C9D38CF-394B-17C2-82AF-91E41E7731E1}"/>
              </a:ext>
            </a:extLst>
          </p:cNvPr>
          <p:cNvSpPr txBox="1"/>
          <p:nvPr/>
        </p:nvSpPr>
        <p:spPr>
          <a:xfrm>
            <a:off x="713649" y="7344832"/>
            <a:ext cx="1371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.3 Retinopathy of prematurity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A3D18A1-E631-DE50-4ADD-CB1C250291F0}"/>
              </a:ext>
            </a:extLst>
          </p:cNvPr>
          <p:cNvSpPr txBox="1"/>
          <p:nvPr/>
        </p:nvSpPr>
        <p:spPr>
          <a:xfrm>
            <a:off x="707948" y="13857188"/>
            <a:ext cx="88429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.5 Intraventricular </a:t>
            </a:r>
            <a:r>
              <a:rPr lang="en-NZ" sz="28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hemorrhage</a:t>
            </a:r>
            <a:endParaRPr lang="en-NZ" sz="28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Graphic 31">
            <a:extLst>
              <a:ext uri="{FF2B5EF4-FFF2-40B4-BE49-F238E27FC236}">
                <a16:creationId xmlns:a16="http://schemas.microsoft.com/office/drawing/2014/main" id="{5727D6BD-9D34-9B03-F3FF-8AAC121B23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98444" y="7865784"/>
            <a:ext cx="13715999" cy="2736360"/>
          </a:xfrm>
          <a:prstGeom prst="rect">
            <a:avLst/>
          </a:prstGeom>
        </p:spPr>
      </p:pic>
      <p:pic>
        <p:nvPicPr>
          <p:cNvPr id="37" name="Graphic 36">
            <a:extLst>
              <a:ext uri="{FF2B5EF4-FFF2-40B4-BE49-F238E27FC236}">
                <a16:creationId xmlns:a16="http://schemas.microsoft.com/office/drawing/2014/main" id="{73998BD4-D727-CF60-3DDE-E82B0B19D4A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07948" y="11123096"/>
            <a:ext cx="13716000" cy="2736360"/>
          </a:xfrm>
          <a:prstGeom prst="rect">
            <a:avLst/>
          </a:prstGeom>
        </p:spPr>
      </p:pic>
      <p:pic>
        <p:nvPicPr>
          <p:cNvPr id="47" name="Graphic 46">
            <a:extLst>
              <a:ext uri="{FF2B5EF4-FFF2-40B4-BE49-F238E27FC236}">
                <a16:creationId xmlns:a16="http://schemas.microsoft.com/office/drawing/2014/main" id="{7D85B45E-39A6-28BE-9C57-9778F82A6F5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707948" y="14377092"/>
            <a:ext cx="13716000" cy="2736360"/>
          </a:xfrm>
          <a:prstGeom prst="rect">
            <a:avLst/>
          </a:prstGeom>
        </p:spPr>
      </p:pic>
      <p:pic>
        <p:nvPicPr>
          <p:cNvPr id="79" name="Graphic 78">
            <a:extLst>
              <a:ext uri="{FF2B5EF4-FFF2-40B4-BE49-F238E27FC236}">
                <a16:creationId xmlns:a16="http://schemas.microsoft.com/office/drawing/2014/main" id="{5EF6F285-7103-541B-858C-703798AAF65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13651" y="1302450"/>
            <a:ext cx="13715999" cy="2736360"/>
          </a:xfrm>
          <a:prstGeom prst="rect">
            <a:avLst/>
          </a:prstGeom>
        </p:spPr>
      </p:pic>
      <p:pic>
        <p:nvPicPr>
          <p:cNvPr id="86" name="Graphic 85">
            <a:extLst>
              <a:ext uri="{FF2B5EF4-FFF2-40B4-BE49-F238E27FC236}">
                <a16:creationId xmlns:a16="http://schemas.microsoft.com/office/drawing/2014/main" id="{23D9D9EE-98D2-DE07-9024-29C51927CCE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713650" y="4585251"/>
            <a:ext cx="13715999" cy="27363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2FC4D48-C251-548F-54C9-7014349674AB}"/>
              </a:ext>
            </a:extLst>
          </p:cNvPr>
          <p:cNvSpPr txBox="1"/>
          <p:nvPr/>
        </p:nvSpPr>
        <p:spPr>
          <a:xfrm>
            <a:off x="707948" y="17113452"/>
            <a:ext cx="1371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.6 Severe intraventricular </a:t>
            </a:r>
            <a:r>
              <a:rPr lang="en-NZ" sz="28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hemorrhage</a:t>
            </a:r>
            <a:r>
              <a:rPr lang="en-NZ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, grade 3 and higher</a:t>
            </a:r>
          </a:p>
        </p:txBody>
      </p:sp>
      <p:pic>
        <p:nvPicPr>
          <p:cNvPr id="9" name="Graphic 8">
            <a:extLst>
              <a:ext uri="{FF2B5EF4-FFF2-40B4-BE49-F238E27FC236}">
                <a16:creationId xmlns:a16="http://schemas.microsoft.com/office/drawing/2014/main" id="{27F857D9-6288-1DDC-0925-02136FD6A7B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707948" y="17633356"/>
            <a:ext cx="13716000" cy="2736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74241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75A6ABB3-69C7-5EAB-4D1C-318B9582FE6B}"/>
              </a:ext>
            </a:extLst>
          </p:cNvPr>
          <p:cNvSpPr txBox="1"/>
          <p:nvPr/>
        </p:nvSpPr>
        <p:spPr>
          <a:xfrm>
            <a:off x="713651" y="7026404"/>
            <a:ext cx="1371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NZ" sz="2800" kern="100" dirty="0">
                <a:latin typeface="Arial" panose="020B0604020202020204" pitchFamily="34" charset="0"/>
                <a:cs typeface="Arial" panose="020B0604020202020204" pitchFamily="34" charset="0"/>
              </a:rPr>
              <a:t>2.9 Growth, weight (g/d) from birth to discharge</a:t>
            </a:r>
          </a:p>
        </p:txBody>
      </p:sp>
      <p:pic>
        <p:nvPicPr>
          <p:cNvPr id="36" name="Graphic 35">
            <a:extLst>
              <a:ext uri="{FF2B5EF4-FFF2-40B4-BE49-F238E27FC236}">
                <a16:creationId xmlns:a16="http://schemas.microsoft.com/office/drawing/2014/main" id="{998A302D-417B-A7F2-F5DF-DD1F2ADD62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13651" y="7549624"/>
            <a:ext cx="13716000" cy="221393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5BCAC6D-DAC6-F49D-0D26-C0DDBA603BFE}"/>
              </a:ext>
            </a:extLst>
          </p:cNvPr>
          <p:cNvSpPr txBox="1"/>
          <p:nvPr/>
        </p:nvSpPr>
        <p:spPr>
          <a:xfrm>
            <a:off x="713651" y="9762764"/>
            <a:ext cx="1371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.10 Mortality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E4F0DA-D9D1-C604-6A42-C8CB2AFE3196}"/>
              </a:ext>
            </a:extLst>
          </p:cNvPr>
          <p:cNvSpPr txBox="1"/>
          <p:nvPr/>
        </p:nvSpPr>
        <p:spPr>
          <a:xfrm>
            <a:off x="713651" y="3778152"/>
            <a:ext cx="1371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.8 Culture-proven sepsi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0573375-4223-C03D-4C1F-57F5DAD3405E}"/>
              </a:ext>
            </a:extLst>
          </p:cNvPr>
          <p:cNvSpPr txBox="1"/>
          <p:nvPr/>
        </p:nvSpPr>
        <p:spPr>
          <a:xfrm>
            <a:off x="713651" y="529900"/>
            <a:ext cx="1371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.7 Necrotising enterocolitis</a:t>
            </a:r>
          </a:p>
        </p:txBody>
      </p:sp>
      <p:pic>
        <p:nvPicPr>
          <p:cNvPr id="53" name="Graphic 52">
            <a:extLst>
              <a:ext uri="{FF2B5EF4-FFF2-40B4-BE49-F238E27FC236}">
                <a16:creationId xmlns:a16="http://schemas.microsoft.com/office/drawing/2014/main" id="{FCBEE3D7-D84F-9206-3F64-FB4F03ED6D1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89701" y="1041792"/>
            <a:ext cx="13716000" cy="2736360"/>
          </a:xfrm>
          <a:prstGeom prst="rect">
            <a:avLst/>
          </a:prstGeom>
        </p:spPr>
      </p:pic>
      <p:pic>
        <p:nvPicPr>
          <p:cNvPr id="69" name="Graphic 68">
            <a:extLst>
              <a:ext uri="{FF2B5EF4-FFF2-40B4-BE49-F238E27FC236}">
                <a16:creationId xmlns:a16="http://schemas.microsoft.com/office/drawing/2014/main" id="{5DF73FB9-275D-9314-5210-2FC7105BFD3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713651" y="4306687"/>
            <a:ext cx="13716000" cy="2736360"/>
          </a:xfrm>
          <a:prstGeom prst="rect">
            <a:avLst/>
          </a:prstGeom>
        </p:spPr>
      </p:pic>
      <p:pic>
        <p:nvPicPr>
          <p:cNvPr id="73" name="Graphic 72">
            <a:extLst>
              <a:ext uri="{FF2B5EF4-FFF2-40B4-BE49-F238E27FC236}">
                <a16:creationId xmlns:a16="http://schemas.microsoft.com/office/drawing/2014/main" id="{CA7E505A-75B6-BA94-7909-5B009628D15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13651" y="10285984"/>
            <a:ext cx="13716000" cy="30099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87251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Graphic 37">
            <a:extLst>
              <a:ext uri="{FF2B5EF4-FFF2-40B4-BE49-F238E27FC236}">
                <a16:creationId xmlns:a16="http://schemas.microsoft.com/office/drawing/2014/main" id="{37C77D4F-7150-E87B-8C21-E3F1BF670A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01675" y="1475125"/>
            <a:ext cx="13716000" cy="2183642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FB502D71-6217-21AD-CB9A-2E79815129FB}"/>
              </a:ext>
            </a:extLst>
          </p:cNvPr>
          <p:cNvSpPr txBox="1"/>
          <p:nvPr/>
        </p:nvSpPr>
        <p:spPr>
          <a:xfrm>
            <a:off x="701675" y="521018"/>
            <a:ext cx="13716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b="1" dirty="0">
                <a:latin typeface="Arial" panose="020B0604020202020204" pitchFamily="34" charset="0"/>
                <a:cs typeface="Arial" panose="020B0604020202020204" pitchFamily="34" charset="0"/>
              </a:rPr>
              <a:t>3 Vitamin E</a:t>
            </a:r>
            <a:endParaRPr lang="en-NZ" b="1" kern="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3.1 Anemia, number of infusions per infant</a:t>
            </a:r>
          </a:p>
        </p:txBody>
      </p:sp>
    </p:spTree>
    <p:extLst>
      <p:ext uri="{BB962C8B-B14F-4D97-AF65-F5344CB8AC3E}">
        <p14:creationId xmlns:p14="http://schemas.microsoft.com/office/powerpoint/2010/main" val="36100643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EC4BFA1F-3BE3-7028-CA7A-B7C553A0AFAE}"/>
              </a:ext>
            </a:extLst>
          </p:cNvPr>
          <p:cNvSpPr txBox="1"/>
          <p:nvPr/>
        </p:nvSpPr>
        <p:spPr>
          <a:xfrm>
            <a:off x="701675" y="564392"/>
            <a:ext cx="13716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b="1" dirty="0">
                <a:latin typeface="Arial" panose="020B0604020202020204" pitchFamily="34" charset="0"/>
                <a:cs typeface="Arial" panose="020B0604020202020204" pitchFamily="34" charset="0"/>
              </a:rPr>
              <a:t>4 Vitamin K</a:t>
            </a:r>
            <a:endParaRPr lang="en-NZ" b="1" kern="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4.1 Intraventricular hemorrhage</a:t>
            </a:r>
          </a:p>
        </p:txBody>
      </p:sp>
      <p:pic>
        <p:nvPicPr>
          <p:cNvPr id="42" name="Graphic 41">
            <a:extLst>
              <a:ext uri="{FF2B5EF4-FFF2-40B4-BE49-F238E27FC236}">
                <a16:creationId xmlns:a16="http://schemas.microsoft.com/office/drawing/2014/main" id="{6D464268-406E-979B-817D-789A3CAB96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01350" y="1518499"/>
            <a:ext cx="13716000" cy="2625072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386318B0-8D50-CCE1-B2FF-00E17BEF008D}"/>
              </a:ext>
            </a:extLst>
          </p:cNvPr>
          <p:cNvSpPr txBox="1"/>
          <p:nvPr/>
        </p:nvSpPr>
        <p:spPr>
          <a:xfrm>
            <a:off x="701350" y="4093551"/>
            <a:ext cx="1371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4.2 Pulmonary hemorrhag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AA33D69-54B8-F685-4D27-77FCA1A6F304}"/>
              </a:ext>
            </a:extLst>
          </p:cNvPr>
          <p:cNvSpPr txBox="1"/>
          <p:nvPr/>
        </p:nvSpPr>
        <p:spPr>
          <a:xfrm>
            <a:off x="701350" y="7187266"/>
            <a:ext cx="1371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4.3 Necrotizing enterocolitis</a:t>
            </a:r>
          </a:p>
        </p:txBody>
      </p:sp>
      <p:pic>
        <p:nvPicPr>
          <p:cNvPr id="48" name="Graphic 47">
            <a:extLst>
              <a:ext uri="{FF2B5EF4-FFF2-40B4-BE49-F238E27FC236}">
                <a16:creationId xmlns:a16="http://schemas.microsoft.com/office/drawing/2014/main" id="{52161B3E-7EE0-DEE2-89F2-E2250E7E95B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01350" y="4616771"/>
            <a:ext cx="13716000" cy="2625072"/>
          </a:xfrm>
          <a:prstGeom prst="rect">
            <a:avLst/>
          </a:prstGeom>
        </p:spPr>
      </p:pic>
      <p:pic>
        <p:nvPicPr>
          <p:cNvPr id="50" name="Graphic 49">
            <a:extLst>
              <a:ext uri="{FF2B5EF4-FFF2-40B4-BE49-F238E27FC236}">
                <a16:creationId xmlns:a16="http://schemas.microsoft.com/office/drawing/2014/main" id="{17C6BEE7-8D7F-DB5F-2B24-BC0361AAC7B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701350" y="7716411"/>
            <a:ext cx="13716000" cy="2625072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083E567D-35E2-861D-7188-C90EA2A4E12C}"/>
              </a:ext>
            </a:extLst>
          </p:cNvPr>
          <p:cNvSpPr txBox="1"/>
          <p:nvPr/>
        </p:nvSpPr>
        <p:spPr>
          <a:xfrm>
            <a:off x="701350" y="10280981"/>
            <a:ext cx="1371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4.4 Clinical bleeding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0E40BE0-6E54-875E-27C2-B35D363504E4}"/>
              </a:ext>
            </a:extLst>
          </p:cNvPr>
          <p:cNvSpPr txBox="1"/>
          <p:nvPr/>
        </p:nvSpPr>
        <p:spPr>
          <a:xfrm>
            <a:off x="701350" y="13339636"/>
            <a:ext cx="1371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4.5 Mortality</a:t>
            </a:r>
          </a:p>
        </p:txBody>
      </p:sp>
      <p:pic>
        <p:nvPicPr>
          <p:cNvPr id="54" name="Graphic 53">
            <a:extLst>
              <a:ext uri="{FF2B5EF4-FFF2-40B4-BE49-F238E27FC236}">
                <a16:creationId xmlns:a16="http://schemas.microsoft.com/office/drawing/2014/main" id="{A5E53B9A-AADB-9DA4-0903-09E6CF60E34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01350" y="10804201"/>
            <a:ext cx="13716000" cy="2535435"/>
          </a:xfrm>
          <a:prstGeom prst="rect">
            <a:avLst/>
          </a:prstGeom>
        </p:spPr>
      </p:pic>
      <p:pic>
        <p:nvPicPr>
          <p:cNvPr id="56" name="Graphic 55">
            <a:extLst>
              <a:ext uri="{FF2B5EF4-FFF2-40B4-BE49-F238E27FC236}">
                <a16:creationId xmlns:a16="http://schemas.microsoft.com/office/drawing/2014/main" id="{7F581DE2-CB37-F01F-E9B1-E69D5D2AED6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701350" y="13862856"/>
            <a:ext cx="13716000" cy="2625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21512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56">
            <a:extLst>
              <a:ext uri="{FF2B5EF4-FFF2-40B4-BE49-F238E27FC236}">
                <a16:creationId xmlns:a16="http://schemas.microsoft.com/office/drawing/2014/main" id="{8AA60919-5649-7340-EA83-6E1DB7B0727E}"/>
              </a:ext>
            </a:extLst>
          </p:cNvPr>
          <p:cNvSpPr txBox="1"/>
          <p:nvPr/>
        </p:nvSpPr>
        <p:spPr>
          <a:xfrm>
            <a:off x="702264" y="471946"/>
            <a:ext cx="1371482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b="1" dirty="0">
                <a:latin typeface="Arial" panose="020B0604020202020204" pitchFamily="34" charset="0"/>
                <a:cs typeface="Arial" panose="020B0604020202020204" pitchFamily="34" charset="0"/>
              </a:rPr>
              <a:t>5 Vitamin C</a:t>
            </a:r>
            <a:endParaRPr lang="en-NZ" b="1" kern="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5.1 Retinopathy of prematurity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65852C7-CB42-4087-F0B8-3747C92CC658}"/>
              </a:ext>
            </a:extLst>
          </p:cNvPr>
          <p:cNvSpPr txBox="1"/>
          <p:nvPr/>
        </p:nvSpPr>
        <p:spPr>
          <a:xfrm>
            <a:off x="701674" y="3814690"/>
            <a:ext cx="1371482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5.2 Intraventricular hemorrhage</a:t>
            </a:r>
          </a:p>
        </p:txBody>
      </p:sp>
      <p:pic>
        <p:nvPicPr>
          <p:cNvPr id="68" name="Graphic 67">
            <a:extLst>
              <a:ext uri="{FF2B5EF4-FFF2-40B4-BE49-F238E27FC236}">
                <a16:creationId xmlns:a16="http://schemas.microsoft.com/office/drawing/2014/main" id="{B8841804-BA18-CBC0-D5C9-784247480A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02264" y="1438765"/>
            <a:ext cx="13714821" cy="2372294"/>
          </a:xfrm>
          <a:prstGeom prst="rect">
            <a:avLst/>
          </a:prstGeom>
        </p:spPr>
      </p:pic>
      <p:pic>
        <p:nvPicPr>
          <p:cNvPr id="70" name="Graphic 69">
            <a:extLst>
              <a:ext uri="{FF2B5EF4-FFF2-40B4-BE49-F238E27FC236}">
                <a16:creationId xmlns:a16="http://schemas.microsoft.com/office/drawing/2014/main" id="{F70B24B4-B68F-C718-24F0-6C0A40019F9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01673" y="4337910"/>
            <a:ext cx="13714821" cy="2588380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4C2B6F63-EF80-A589-5B79-DD9B52260CC4}"/>
              </a:ext>
            </a:extLst>
          </p:cNvPr>
          <p:cNvSpPr txBox="1"/>
          <p:nvPr/>
        </p:nvSpPr>
        <p:spPr>
          <a:xfrm>
            <a:off x="701666" y="16061347"/>
            <a:ext cx="1371482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5.8 Anemia, number of transfusions per infant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4273051-365E-5B49-B3A6-47525D0D35B9}"/>
              </a:ext>
            </a:extLst>
          </p:cNvPr>
          <p:cNvSpPr txBox="1"/>
          <p:nvPr/>
        </p:nvSpPr>
        <p:spPr>
          <a:xfrm>
            <a:off x="701670" y="10037890"/>
            <a:ext cx="1371482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5.4 Necrotizing enterocolitis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C67B581-276C-13B7-78A6-526CB7E48D1D}"/>
              </a:ext>
            </a:extLst>
          </p:cNvPr>
          <p:cNvSpPr txBox="1"/>
          <p:nvPr/>
        </p:nvSpPr>
        <p:spPr>
          <a:xfrm>
            <a:off x="701668" y="12949747"/>
            <a:ext cx="1371482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5.5 Culture-proven sepsi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ECA9371-ABC9-2BAF-A966-63F27A9C3D31}"/>
              </a:ext>
            </a:extLst>
          </p:cNvPr>
          <p:cNvSpPr txBox="1"/>
          <p:nvPr/>
        </p:nvSpPr>
        <p:spPr>
          <a:xfrm>
            <a:off x="701672" y="6926290"/>
            <a:ext cx="1371482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5.3 Severe intraventricular hemorrhage, grade 3 and higher</a:t>
            </a:r>
          </a:p>
        </p:txBody>
      </p:sp>
      <p:pic>
        <p:nvPicPr>
          <p:cNvPr id="72" name="Graphic 71">
            <a:extLst>
              <a:ext uri="{FF2B5EF4-FFF2-40B4-BE49-F238E27FC236}">
                <a16:creationId xmlns:a16="http://schemas.microsoft.com/office/drawing/2014/main" id="{DACDE3D8-D1C3-2E96-BE51-48CC56F4269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701671" y="7462222"/>
            <a:ext cx="13714821" cy="2588380"/>
          </a:xfrm>
          <a:prstGeom prst="rect">
            <a:avLst/>
          </a:prstGeom>
        </p:spPr>
      </p:pic>
      <p:pic>
        <p:nvPicPr>
          <p:cNvPr id="76" name="Graphic 75">
            <a:extLst>
              <a:ext uri="{FF2B5EF4-FFF2-40B4-BE49-F238E27FC236}">
                <a16:creationId xmlns:a16="http://schemas.microsoft.com/office/drawing/2014/main" id="{143201C0-B2DD-FEF8-6A7A-032BB9D779D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01669" y="10586534"/>
            <a:ext cx="13714821" cy="2369731"/>
          </a:xfrm>
          <a:prstGeom prst="rect">
            <a:avLst/>
          </a:prstGeom>
        </p:spPr>
      </p:pic>
      <p:pic>
        <p:nvPicPr>
          <p:cNvPr id="78" name="Graphic 77">
            <a:extLst>
              <a:ext uri="{FF2B5EF4-FFF2-40B4-BE49-F238E27FC236}">
                <a16:creationId xmlns:a16="http://schemas.microsoft.com/office/drawing/2014/main" id="{F8EEA25C-3C2A-9013-10AF-2321748CAA9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701667" y="13472967"/>
            <a:ext cx="13714821" cy="2588380"/>
          </a:xfrm>
          <a:prstGeom prst="rect">
            <a:avLst/>
          </a:prstGeom>
        </p:spPr>
      </p:pic>
      <p:pic>
        <p:nvPicPr>
          <p:cNvPr id="81" name="Graphic 80">
            <a:extLst>
              <a:ext uri="{FF2B5EF4-FFF2-40B4-BE49-F238E27FC236}">
                <a16:creationId xmlns:a16="http://schemas.microsoft.com/office/drawing/2014/main" id="{808B1C66-38FC-1454-89AE-632C82A0CD6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701665" y="16584567"/>
            <a:ext cx="13714821" cy="2210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445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Box 63">
            <a:extLst>
              <a:ext uri="{FF2B5EF4-FFF2-40B4-BE49-F238E27FC236}">
                <a16:creationId xmlns:a16="http://schemas.microsoft.com/office/drawing/2014/main" id="{01DBE269-231F-9147-9EE2-4C78EE25586C}"/>
              </a:ext>
            </a:extLst>
          </p:cNvPr>
          <p:cNvSpPr txBox="1"/>
          <p:nvPr/>
        </p:nvSpPr>
        <p:spPr>
          <a:xfrm>
            <a:off x="702264" y="523218"/>
            <a:ext cx="1371482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5.9 Anemia, number of infants who required transfusion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030EF31-DCBE-2397-7A41-65858DD135D1}"/>
              </a:ext>
            </a:extLst>
          </p:cNvPr>
          <p:cNvSpPr txBox="1"/>
          <p:nvPr/>
        </p:nvSpPr>
        <p:spPr>
          <a:xfrm>
            <a:off x="701674" y="3634818"/>
            <a:ext cx="1371482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5.10 Growth, weight (g/d), from day 7 to day 14 of exposure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AE02058-29C9-63B1-B1F3-217193872B96}"/>
              </a:ext>
            </a:extLst>
          </p:cNvPr>
          <p:cNvSpPr txBox="1"/>
          <p:nvPr/>
        </p:nvSpPr>
        <p:spPr>
          <a:xfrm>
            <a:off x="701673" y="6368992"/>
            <a:ext cx="1371482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5.11 Mortality</a:t>
            </a:r>
          </a:p>
        </p:txBody>
      </p:sp>
      <p:pic>
        <p:nvPicPr>
          <p:cNvPr id="83" name="Graphic 82">
            <a:extLst>
              <a:ext uri="{FF2B5EF4-FFF2-40B4-BE49-F238E27FC236}">
                <a16:creationId xmlns:a16="http://schemas.microsoft.com/office/drawing/2014/main" id="{34C723CF-E0A0-A061-A0D3-FA85328EC9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01674" y="1046438"/>
            <a:ext cx="13714821" cy="2588380"/>
          </a:xfrm>
          <a:prstGeom prst="rect">
            <a:avLst/>
          </a:prstGeom>
        </p:spPr>
      </p:pic>
      <p:pic>
        <p:nvPicPr>
          <p:cNvPr id="85" name="Graphic 84">
            <a:extLst>
              <a:ext uri="{FF2B5EF4-FFF2-40B4-BE49-F238E27FC236}">
                <a16:creationId xmlns:a16="http://schemas.microsoft.com/office/drawing/2014/main" id="{1FBFA2CA-0E3A-FCA4-2F99-7D2FB28C528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01673" y="4158038"/>
            <a:ext cx="13714821" cy="2210954"/>
          </a:xfrm>
          <a:prstGeom prst="rect">
            <a:avLst/>
          </a:prstGeom>
        </p:spPr>
      </p:pic>
      <p:pic>
        <p:nvPicPr>
          <p:cNvPr id="87" name="Graphic 86">
            <a:extLst>
              <a:ext uri="{FF2B5EF4-FFF2-40B4-BE49-F238E27FC236}">
                <a16:creationId xmlns:a16="http://schemas.microsoft.com/office/drawing/2014/main" id="{2907FB7A-5ADF-0282-9086-414B08C0744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701672" y="6892212"/>
            <a:ext cx="13714821" cy="23697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12634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Box 87">
            <a:extLst>
              <a:ext uri="{FF2B5EF4-FFF2-40B4-BE49-F238E27FC236}">
                <a16:creationId xmlns:a16="http://schemas.microsoft.com/office/drawing/2014/main" id="{556FCC52-795A-E545-637D-D3CDA92C5D76}"/>
              </a:ext>
            </a:extLst>
          </p:cNvPr>
          <p:cNvSpPr txBox="1"/>
          <p:nvPr/>
        </p:nvSpPr>
        <p:spPr>
          <a:xfrm>
            <a:off x="701675" y="551092"/>
            <a:ext cx="13716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2800" b="1" dirty="0">
                <a:latin typeface="Arial" panose="020B0604020202020204" pitchFamily="34" charset="0"/>
                <a:cs typeface="Arial" panose="020B0604020202020204" pitchFamily="34" charset="0"/>
              </a:rPr>
              <a:t>6 Vitamin B</a:t>
            </a:r>
            <a:r>
              <a:rPr lang="en-NZ" sz="2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NZ" sz="2800" b="1" dirty="0">
                <a:latin typeface="Arial" panose="020B0604020202020204" pitchFamily="34" charset="0"/>
                <a:cs typeface="Arial" panose="020B0604020202020204" pitchFamily="34" charset="0"/>
              </a:rPr>
              <a:t> and folate</a:t>
            </a:r>
            <a:endParaRPr lang="en-NZ" b="1" kern="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6.1 Necrotizing enterocolitis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66B8940-AC7D-3B4E-C7E5-E8B5FBA8DAAD}"/>
              </a:ext>
            </a:extLst>
          </p:cNvPr>
          <p:cNvSpPr txBox="1"/>
          <p:nvPr/>
        </p:nvSpPr>
        <p:spPr>
          <a:xfrm>
            <a:off x="701675" y="7033801"/>
            <a:ext cx="1371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6.3 Mortality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97789E9-272D-3019-568D-055FF70243DD}"/>
              </a:ext>
            </a:extLst>
          </p:cNvPr>
          <p:cNvSpPr txBox="1"/>
          <p:nvPr/>
        </p:nvSpPr>
        <p:spPr>
          <a:xfrm>
            <a:off x="701675" y="4008500"/>
            <a:ext cx="13716000" cy="522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1">
              <a:spcAft>
                <a:spcPts val="600"/>
              </a:spcAft>
            </a:pPr>
            <a:r>
              <a:rPr lang="en-US" sz="2800" kern="100" dirty="0">
                <a:latin typeface="Arial" panose="020B0604020202020204" pitchFamily="34" charset="0"/>
                <a:cs typeface="Arial" panose="020B0604020202020204" pitchFamily="34" charset="0"/>
              </a:rPr>
              <a:t>6.2 Anemia, number of infants who required transfusions</a:t>
            </a:r>
          </a:p>
        </p:txBody>
      </p:sp>
      <p:pic>
        <p:nvPicPr>
          <p:cNvPr id="98" name="Graphic 97">
            <a:extLst>
              <a:ext uri="{FF2B5EF4-FFF2-40B4-BE49-F238E27FC236}">
                <a16:creationId xmlns:a16="http://schemas.microsoft.com/office/drawing/2014/main" id="{28DA7894-9FEF-C4AB-6D35-2219BD0BD4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01675" y="1505199"/>
            <a:ext cx="13716000" cy="2503301"/>
          </a:xfrm>
          <a:prstGeom prst="rect">
            <a:avLst/>
          </a:prstGeom>
        </p:spPr>
      </p:pic>
      <p:pic>
        <p:nvPicPr>
          <p:cNvPr id="100" name="Graphic 99">
            <a:extLst>
              <a:ext uri="{FF2B5EF4-FFF2-40B4-BE49-F238E27FC236}">
                <a16:creationId xmlns:a16="http://schemas.microsoft.com/office/drawing/2014/main" id="{121150F1-539E-A7D5-652E-E783BC54244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01675" y="4530500"/>
            <a:ext cx="13716000" cy="2503301"/>
          </a:xfrm>
          <a:prstGeom prst="rect">
            <a:avLst/>
          </a:prstGeom>
        </p:spPr>
      </p:pic>
      <p:pic>
        <p:nvPicPr>
          <p:cNvPr id="102" name="Graphic 101">
            <a:extLst>
              <a:ext uri="{FF2B5EF4-FFF2-40B4-BE49-F238E27FC236}">
                <a16:creationId xmlns:a16="http://schemas.microsoft.com/office/drawing/2014/main" id="{5B280C59-606F-45AA-FF9B-7F99051EDE5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701675" y="7557021"/>
            <a:ext cx="13716000" cy="25033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7879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</TotalTime>
  <Words>281</Words>
  <Application>Microsoft Office PowerPoint</Application>
  <PresentationFormat>Custom</PresentationFormat>
  <Paragraphs>41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a Bronnert</dc:creator>
  <cp:lastModifiedBy>Anja Bronnert</cp:lastModifiedBy>
  <cp:revision>1</cp:revision>
  <dcterms:created xsi:type="dcterms:W3CDTF">2024-03-11T21:46:19Z</dcterms:created>
  <dcterms:modified xsi:type="dcterms:W3CDTF">2024-03-15T03:09:45Z</dcterms:modified>
</cp:coreProperties>
</file>